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4" r:id="rId2"/>
    <p:sldId id="401" r:id="rId3"/>
    <p:sldId id="256" r:id="rId4"/>
    <p:sldId id="262" r:id="rId5"/>
    <p:sldId id="301" r:id="rId6"/>
    <p:sldId id="393" r:id="rId7"/>
    <p:sldId id="400" r:id="rId8"/>
    <p:sldId id="402" r:id="rId9"/>
    <p:sldId id="394" r:id="rId10"/>
    <p:sldId id="305" r:id="rId11"/>
    <p:sldId id="306" r:id="rId12"/>
    <p:sldId id="392" r:id="rId13"/>
    <p:sldId id="399" r:id="rId14"/>
    <p:sldId id="396" r:id="rId15"/>
    <p:sldId id="397" r:id="rId1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95" d="100"/>
          <a:sy n="95" d="100"/>
        </p:scale>
        <p:origin x="20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23A7E4-8CC0-52A8-5A7D-D98125C3C4E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D132EDD-A7A8-866F-7DA1-06B5A5EA377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2A80C5-04F4-8DCD-D102-76692E5787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6D4AC-BF6D-40FC-B9DA-DC3777C76B0A}" type="datetimeFigureOut">
              <a:rPr lang="en-IN" smtClean="0"/>
              <a:t>05-1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A1A172-A23D-4001-859A-92DC5756F5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380560-1DBA-E92A-786B-0AC4ECF915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EF9AE-30E3-40E4-9406-92E55F1ADC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494234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B68FBC-0D67-E69E-B3EB-5230827CA7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82D448F-6A0D-305A-384D-168995DB43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6178AB-B49B-ADF7-93EF-6C03D49A15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6D4AC-BF6D-40FC-B9DA-DC3777C76B0A}" type="datetimeFigureOut">
              <a:rPr lang="en-IN" smtClean="0"/>
              <a:t>05-1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AB81E7-D0DC-4416-7F33-DB7D5AB2D0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B2EA4A-9EC7-A8E3-60F5-8A05E3201A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EF9AE-30E3-40E4-9406-92E55F1ADC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021246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8F49EEF-24DA-3598-68B6-16042E0CDF5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820B0B8-3B64-254B-7AF3-475B732733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ACF5A1-86B4-779C-2A5D-F2AD26FC0A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6D4AC-BF6D-40FC-B9DA-DC3777C76B0A}" type="datetimeFigureOut">
              <a:rPr lang="en-IN" smtClean="0"/>
              <a:t>05-1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717622-2225-07CE-6BEB-9205D41710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31C38D-95BC-1FDC-CC53-91D0B55311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EF9AE-30E3-40E4-9406-92E55F1ADC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36881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916BE8-DC41-0DC9-CDB6-470EECE258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AD53CF-58E6-EC77-7FB3-D2A9A5F91C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2E2ED8-0DB2-1C7F-5F55-9FD378256C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6D4AC-BF6D-40FC-B9DA-DC3777C76B0A}" type="datetimeFigureOut">
              <a:rPr lang="en-IN" smtClean="0"/>
              <a:t>05-1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AB71D7-6003-FB55-8BB3-050F56F45C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A6DA59-5997-F03D-8743-D625677AE2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EF9AE-30E3-40E4-9406-92E55F1ADC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209798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3BB74B-040D-B874-ACEC-48312430C8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2D400F-C18B-72F5-4B25-9953B61E67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E32BA6-AC79-DBC2-2DEE-7D0DFAA0C1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6D4AC-BF6D-40FC-B9DA-DC3777C76B0A}" type="datetimeFigureOut">
              <a:rPr lang="en-IN" smtClean="0"/>
              <a:t>05-1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C5D0C4-12A4-1673-4A83-9D84A152F3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F578BC-B6EC-CBA0-2CEC-A8DBDEAC02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EF9AE-30E3-40E4-9406-92E55F1ADC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469918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9DF7ED-4D48-1E9A-6BDE-467EAA775A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01A774-A365-C9C7-E2F1-8303B1BAE44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B0431C7-A459-285B-75B7-0DFF21ACBA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CBF3B9-3E5B-F353-FEDF-6558F3BDF4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6D4AC-BF6D-40FC-B9DA-DC3777C76B0A}" type="datetimeFigureOut">
              <a:rPr lang="en-IN" smtClean="0"/>
              <a:t>05-12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36C50C9-C8B3-F4FD-1AB5-877A529653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FCB2140-DEAA-04D5-894F-DB81A3958D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EF9AE-30E3-40E4-9406-92E55F1ADC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522026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B61394-040D-ECBD-5B23-E587DE2040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0354B6D-C37C-B20B-8402-34B4A4D9FA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C9124F8-C3F3-F13B-FF5D-4F40E5FED7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AD21DA9-13A4-4078-03BF-49CB467F78B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3694E17-4A3C-3C98-A2D6-9FF1E351F39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25FB545-1882-C5FF-3EEA-F48A88CA3C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6D4AC-BF6D-40FC-B9DA-DC3777C76B0A}" type="datetimeFigureOut">
              <a:rPr lang="en-IN" smtClean="0"/>
              <a:t>05-12-2024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7BA87D8-EA8B-18BD-FC00-5A3CE522E0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D21F260-75C7-30B9-5779-0F4C98A5EF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EF9AE-30E3-40E4-9406-92E55F1ADC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771471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8F5C7E-6B10-4500-2E53-D1D9BCDAF0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97B08D2-A6C8-AEAE-7915-6A894AC6C1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6D4AC-BF6D-40FC-B9DA-DC3777C76B0A}" type="datetimeFigureOut">
              <a:rPr lang="en-IN" smtClean="0"/>
              <a:t>05-12-2024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AB23B84-7C2B-F724-CD6B-EFF3B9B79E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C6A5A0E-6A29-41E2-FE5C-893522BA04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EF9AE-30E3-40E4-9406-92E55F1ADC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118268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157DA88-9E51-5A8E-8AE6-90DF7698F0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6D4AC-BF6D-40FC-B9DA-DC3777C76B0A}" type="datetimeFigureOut">
              <a:rPr lang="en-IN" smtClean="0"/>
              <a:t>05-12-2024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1D8782D-7B82-6C6E-AD7B-A767E536A7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5571859-4DF9-820E-482A-7563691A2A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EF9AE-30E3-40E4-9406-92E55F1ADC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57550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CA81F8-C9D8-6D45-71D4-A52937EE3C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0EA5B4-40B9-4C81-A725-234EE08E6AA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59105A9-2EAC-60CC-2DEC-B1C7A9505C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81488BC-4E14-8BDF-8BE2-78B86F0C86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6D4AC-BF6D-40FC-B9DA-DC3777C76B0A}" type="datetimeFigureOut">
              <a:rPr lang="en-IN" smtClean="0"/>
              <a:t>05-12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E2B944C-D96C-F828-93D5-C80818D1BC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558B9A8-C48B-8C25-6A8C-831B97B74F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EF9AE-30E3-40E4-9406-92E55F1ADC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416871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D684FC-A64E-511F-C367-233EC617DD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11E7698-4B61-737A-9388-02B0CDCD1EF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04006DF-72A3-23AB-6133-CB6E18B2D5E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1BBDB6C-D851-9206-5807-1EDE03B42C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6D4AC-BF6D-40FC-B9DA-DC3777C76B0A}" type="datetimeFigureOut">
              <a:rPr lang="en-IN" smtClean="0"/>
              <a:t>05-12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DD7E49B-787C-15C6-6E7D-CE34171580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D6029E-D353-EE6C-0AB0-AEA71B2B00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EF9AE-30E3-40E4-9406-92E55F1ADC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599266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868AEFC-11E4-99AC-B55C-42DC4D9D9C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E521D43-D5BB-966D-9616-E0F9621B28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861296-E6A2-718C-FFED-24BA6AEF8C8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46D4AC-BF6D-40FC-B9DA-DC3777C76B0A}" type="datetimeFigureOut">
              <a:rPr lang="en-IN" smtClean="0"/>
              <a:t>05-1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675620-77A3-0347-D0C0-46E29D91FFB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8F006C-6E85-D57D-A7AF-5843320331D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BEF9AE-30E3-40E4-9406-92E55F1ADC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629927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g"/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8.jpg"/><Relationship Id="rId4" Type="http://schemas.openxmlformats.org/officeDocument/2006/relationships/image" Target="../media/image17.jpg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3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jpeg"/><Relationship Id="rId3" Type="http://schemas.openxmlformats.org/officeDocument/2006/relationships/image" Target="../media/image6.jpg"/><Relationship Id="rId7" Type="http://schemas.openxmlformats.org/officeDocument/2006/relationships/image" Target="../media/image8.emf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5.bin"/><Relationship Id="rId5" Type="http://schemas.openxmlformats.org/officeDocument/2006/relationships/image" Target="../media/image7.emf"/><Relationship Id="rId4" Type="http://schemas.openxmlformats.org/officeDocument/2006/relationships/oleObject" Target="../embeddings/oleObject4.bin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5AD48AF2-2970-40AB-81DE-DADB2AEE5A65}"/>
              </a:ext>
            </a:extLst>
          </p:cNvPr>
          <p:cNvSpPr txBox="1"/>
          <p:nvPr/>
        </p:nvSpPr>
        <p:spPr>
          <a:xfrm>
            <a:off x="1355324" y="1074198"/>
            <a:ext cx="9481352" cy="42780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ctr">
              <a:spcBef>
                <a:spcPts val="0"/>
              </a:spcBef>
              <a:spcAft>
                <a:spcPts val="800"/>
              </a:spcAft>
            </a:pPr>
            <a:r>
              <a:rPr lang="en-US" b="1" u="none" strike="noStrike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 Azomethine derivative, BCS3 targets XIAP &amp; cIAP1/2 to arrest Breast Cancer Progression through MDM2-p53 and Bcl-2-Caspase Signaling Modulation</a:t>
            </a:r>
          </a:p>
          <a:p>
            <a:pPr marL="0" marR="0" algn="ctr">
              <a:spcBef>
                <a:spcPts val="0"/>
              </a:spcBef>
              <a:spcAft>
                <a:spcPts val="800"/>
              </a:spcAft>
            </a:pPr>
            <a:r>
              <a:rPr lang="en-US" sz="1400" b="1" u="none" strike="noStrike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etuparna Acharya </a:t>
            </a:r>
            <a:r>
              <a:rPr lang="en-US" sz="1400" b="1" u="none" strike="noStrike" baseline="300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400" b="1" u="none" strike="noStrike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Pran Kishore Deb </a:t>
            </a:r>
            <a:r>
              <a:rPr lang="en-US" sz="1400" b="1" u="none" strike="noStrike" baseline="300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,*</a:t>
            </a:r>
            <a:r>
              <a:rPr lang="en-US" sz="1400" b="1" u="none" strike="noStrike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Katharigatta N. Venugopala </a:t>
            </a:r>
            <a:r>
              <a:rPr lang="en-US" sz="1400" b="1" u="none" strike="noStrike" baseline="300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, </a:t>
            </a:r>
            <a:r>
              <a:rPr lang="en-US" sz="1400" b="1" u="none" strike="noStrike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Shakti Prasad Pattanayak </a:t>
            </a:r>
            <a:r>
              <a:rPr lang="en-US" sz="1400" b="1" u="none" strike="noStrike" baseline="300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,*</a:t>
            </a:r>
          </a:p>
          <a:p>
            <a:pPr marL="0" marR="0" algn="ctr">
              <a:spcBef>
                <a:spcPts val="0"/>
              </a:spcBef>
              <a:spcAft>
                <a:spcPts val="800"/>
              </a:spcAft>
            </a:pPr>
            <a:r>
              <a:rPr lang="en-US" sz="1400" u="none" strike="noStrike" baseline="300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400" u="none" strike="noStrike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vision of Advanced Pharmacology, Department of Pharmaceutical Sciences &amp; Technology, Birla Institute of Technology, Mesra, 835215, Ranchi, India; phdph10051.18@bitmesra.ac.in (R.A.)</a:t>
            </a:r>
          </a:p>
          <a:p>
            <a:pPr marL="0" marR="0" algn="ctr">
              <a:spcBef>
                <a:spcPts val="0"/>
              </a:spcBef>
              <a:spcAft>
                <a:spcPts val="800"/>
              </a:spcAft>
            </a:pPr>
            <a:r>
              <a:rPr lang="en-US" sz="1400" u="none" strike="noStrike" baseline="300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400" u="none" strike="noStrike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Pharmaceutical Sciences and Technology, Birla Institute of Technology (BIT), Mesra, Ranchi, 835215 India: E-mail: prankishore1@gmail.com; prankishoredeb@bitmesra.ac.in (P.K.D.); ORCID: http://orcid.org/0000-0002-8650-2874</a:t>
            </a:r>
          </a:p>
          <a:p>
            <a:pPr marL="0" marR="0" algn="ctr">
              <a:spcBef>
                <a:spcPts val="0"/>
              </a:spcBef>
              <a:spcAft>
                <a:spcPts val="800"/>
              </a:spcAft>
            </a:pPr>
            <a:r>
              <a:rPr lang="en-US" sz="1400" u="none" strike="noStrike" baseline="300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400" u="none" strike="noStrike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Pharmaceutical Sciences, College of Clinical Pharmacy, King Faisal University, Al-Ahsa 31982, Saudi Arabia: E-mail: venugopalakn@gmail.com; kvenugopala@kfu.edu.sa (K.N.V.); ORCID: https://orcid.org/0000-0003-0680-1549</a:t>
            </a:r>
          </a:p>
          <a:p>
            <a:pPr marL="0" marR="0" algn="ctr">
              <a:spcBef>
                <a:spcPts val="0"/>
              </a:spcBef>
              <a:spcAft>
                <a:spcPts val="800"/>
              </a:spcAft>
            </a:pPr>
            <a:r>
              <a:rPr lang="en-US" sz="1400" u="none" strike="noStrike" baseline="300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sz="1400" u="none" strike="noStrike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Biochemistry, School of Medicine, Case Western Reserve University, Woods building, W437, 2109 Adelbert Road, Cleaveland, Ohio, 44106, USA. E-mail: profsppattanayak@gmail.com; sxp1286@case.edu (S.P.P.); ORCID: https://orcid.org/0000-0002-1629-2648</a:t>
            </a:r>
          </a:p>
          <a:p>
            <a:pPr marL="0" marR="0" algn="ctr">
              <a:spcBef>
                <a:spcPts val="0"/>
              </a:spcBef>
              <a:spcAft>
                <a:spcPts val="800"/>
              </a:spcAft>
            </a:pPr>
            <a:r>
              <a:rPr lang="en-US" sz="1400" u="none" strike="noStrike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Correspondence: prankishore1@gmail.com; prankishoredeb@bitmesra.ac.in (P.K.D</a:t>
            </a:r>
            <a:r>
              <a:rPr lang="en-US" sz="1400" u="none" strike="noStrike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); profsppattanayak</a:t>
            </a:r>
            <a:r>
              <a:rPr lang="en-US" sz="1400" u="none" strike="noStrike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@gmail.com; sxp1286@case.edu (S.P.P.)</a:t>
            </a:r>
          </a:p>
        </p:txBody>
      </p:sp>
    </p:spTree>
    <p:extLst>
      <p:ext uri="{BB962C8B-B14F-4D97-AF65-F5344CB8AC3E}">
        <p14:creationId xmlns:p14="http://schemas.microsoft.com/office/powerpoint/2010/main" val="246568734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95E7E5F2-9133-68B0-65F7-A8E976C24E9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37" r="1190"/>
          <a:stretch/>
        </p:blipFill>
        <p:spPr>
          <a:xfrm>
            <a:off x="147961" y="656260"/>
            <a:ext cx="11896078" cy="55454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D454E92-9F43-E5ED-5F62-2A9D7D917397}"/>
              </a:ext>
            </a:extLst>
          </p:cNvPr>
          <p:cNvSpPr txBox="1"/>
          <p:nvPr/>
        </p:nvSpPr>
        <p:spPr>
          <a:xfrm>
            <a:off x="0" y="6441646"/>
            <a:ext cx="12191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6. </a:t>
            </a:r>
            <a:r>
              <a:rPr lang="en-I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Probable metabolites of BCS3 (M1-M9) after biotransformation through Phase I (CYP450) transformation predicted by using </a:t>
            </a:r>
            <a:r>
              <a:rPr lang="en-IN" sz="12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BioTransformer</a:t>
            </a:r>
            <a:r>
              <a:rPr lang="en-I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3.0 online software.</a:t>
            </a:r>
          </a:p>
        </p:txBody>
      </p:sp>
    </p:spTree>
    <p:extLst>
      <p:ext uri="{BB962C8B-B14F-4D97-AF65-F5344CB8AC3E}">
        <p14:creationId xmlns:p14="http://schemas.microsoft.com/office/powerpoint/2010/main" val="427433825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3C6FD5E-8A1B-EE32-F9E6-2166F4331BE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7" r="1117"/>
          <a:stretch/>
        </p:blipFill>
        <p:spPr>
          <a:xfrm>
            <a:off x="125767" y="554209"/>
            <a:ext cx="11940466" cy="589162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37600CD-3226-8A5A-240D-31CAC6CF83DC}"/>
              </a:ext>
            </a:extLst>
          </p:cNvPr>
          <p:cNvSpPr txBox="1"/>
          <p:nvPr/>
        </p:nvSpPr>
        <p:spPr>
          <a:xfrm>
            <a:off x="387657" y="6445835"/>
            <a:ext cx="115942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6 (cont.). </a:t>
            </a:r>
            <a:r>
              <a:rPr lang="en-IN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Predicted metabolites of BCS3 after biotransformation through Phase I (CYP450) transformation.</a:t>
            </a:r>
          </a:p>
        </p:txBody>
      </p:sp>
    </p:spTree>
    <p:extLst>
      <p:ext uri="{BB962C8B-B14F-4D97-AF65-F5344CB8AC3E}">
        <p14:creationId xmlns:p14="http://schemas.microsoft.com/office/powerpoint/2010/main" val="174773666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037DE50-DA2C-2EB8-F147-DA07A418FBB8}"/>
              </a:ext>
            </a:extLst>
          </p:cNvPr>
          <p:cNvSpPr txBox="1"/>
          <p:nvPr/>
        </p:nvSpPr>
        <p:spPr>
          <a:xfrm>
            <a:off x="260135" y="2636103"/>
            <a:ext cx="7928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C10AB2D-0049-1241-A89F-39C21AA77F3F}"/>
              </a:ext>
            </a:extLst>
          </p:cNvPr>
          <p:cNvSpPr txBox="1"/>
          <p:nvPr/>
        </p:nvSpPr>
        <p:spPr>
          <a:xfrm>
            <a:off x="298881" y="6049001"/>
            <a:ext cx="1159423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7. </a:t>
            </a:r>
            <a:r>
              <a:rPr lang="en-IN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Real Time Quantitative Polymerase Chain Reaction (RT-qPCR) of (a) Inhibition of apoptosis proteins, (b) Critical apoptotic proteins (c) Caspases and (d) Cell cycle proteins in MDA-MB-231 cells after treatment with BCS3 (0.8, 1.6 and 3.2 µM doses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5E97809-5750-9331-51EE-6416FF5897C3}"/>
              </a:ext>
            </a:extLst>
          </p:cNvPr>
          <p:cNvSpPr txBox="1"/>
          <p:nvPr/>
        </p:nvSpPr>
        <p:spPr>
          <a:xfrm>
            <a:off x="5554710" y="2613465"/>
            <a:ext cx="7928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1CCA070-AD1A-FFA2-17E8-DCDD9CBE250C}"/>
              </a:ext>
            </a:extLst>
          </p:cNvPr>
          <p:cNvSpPr txBox="1"/>
          <p:nvPr/>
        </p:nvSpPr>
        <p:spPr>
          <a:xfrm>
            <a:off x="298881" y="5568917"/>
            <a:ext cx="7928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AE54A50-BF84-0E4B-39B8-7696CE6178C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2358" y="3079421"/>
            <a:ext cx="4612858" cy="296958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75548329-C1E8-577D-224C-484D3AEB66EC}"/>
              </a:ext>
            </a:extLst>
          </p:cNvPr>
          <p:cNvSpPr txBox="1"/>
          <p:nvPr/>
        </p:nvSpPr>
        <p:spPr>
          <a:xfrm>
            <a:off x="5559168" y="5642831"/>
            <a:ext cx="7928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8C51BD3-8748-EEFE-BAD5-313C08ADF76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47514" y="3051701"/>
            <a:ext cx="4311865" cy="302502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78AB63A-6D32-1535-5A30-13805B69ECD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999" y="166309"/>
            <a:ext cx="5344006" cy="2839916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59EE2073-B715-EB51-58E3-3CDB55C0B99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5572" y="138589"/>
            <a:ext cx="4612858" cy="29131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37100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1A4C1153-BA63-0898-8AAD-E40089CA9A4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71802980"/>
              </p:ext>
            </p:extLst>
          </p:nvPr>
        </p:nvGraphicFramePr>
        <p:xfrm>
          <a:off x="1305018" y="992075"/>
          <a:ext cx="9774315" cy="2990357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377901">
                  <a:extLst>
                    <a:ext uri="{9D8B030D-6E8A-4147-A177-3AD203B41FA5}">
                      <a16:colId xmlns:a16="http://schemas.microsoft.com/office/drawing/2014/main" val="3535852324"/>
                    </a:ext>
                  </a:extLst>
                </a:gridCol>
                <a:gridCol w="1690124">
                  <a:extLst>
                    <a:ext uri="{9D8B030D-6E8A-4147-A177-3AD203B41FA5}">
                      <a16:colId xmlns:a16="http://schemas.microsoft.com/office/drawing/2014/main" val="3817727404"/>
                    </a:ext>
                  </a:extLst>
                </a:gridCol>
                <a:gridCol w="1691208">
                  <a:extLst>
                    <a:ext uri="{9D8B030D-6E8A-4147-A177-3AD203B41FA5}">
                      <a16:colId xmlns:a16="http://schemas.microsoft.com/office/drawing/2014/main" val="1602430822"/>
                    </a:ext>
                  </a:extLst>
                </a:gridCol>
                <a:gridCol w="1690124">
                  <a:extLst>
                    <a:ext uri="{9D8B030D-6E8A-4147-A177-3AD203B41FA5}">
                      <a16:colId xmlns:a16="http://schemas.microsoft.com/office/drawing/2014/main" val="515057318"/>
                    </a:ext>
                  </a:extLst>
                </a:gridCol>
                <a:gridCol w="1690124">
                  <a:extLst>
                    <a:ext uri="{9D8B030D-6E8A-4147-A177-3AD203B41FA5}">
                      <a16:colId xmlns:a16="http://schemas.microsoft.com/office/drawing/2014/main" val="1596757040"/>
                    </a:ext>
                  </a:extLst>
                </a:gridCol>
                <a:gridCol w="1634834">
                  <a:extLst>
                    <a:ext uri="{9D8B030D-6E8A-4147-A177-3AD203B41FA5}">
                      <a16:colId xmlns:a16="http://schemas.microsoft.com/office/drawing/2014/main" val="2083709659"/>
                    </a:ext>
                  </a:extLst>
                </a:gridCol>
              </a:tblGrid>
              <a:tr h="418921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500" b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. of days</a:t>
                      </a:r>
                      <a:endParaRPr lang="en-IN" sz="1500" b="1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500" b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Group I</a:t>
                      </a:r>
                      <a:endParaRPr lang="en-IN" sz="1500" b="1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500" b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Group II</a:t>
                      </a:r>
                      <a:endParaRPr lang="en-IN" sz="1500" b="1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500" b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Group III</a:t>
                      </a:r>
                      <a:endParaRPr lang="en-IN" sz="1500" b="1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500" b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Group IV</a:t>
                      </a:r>
                      <a:endParaRPr lang="en-IN" sz="1500" b="1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500" b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Group V</a:t>
                      </a:r>
                      <a:endParaRPr lang="en-IN" sz="1500" b="1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768531242"/>
                  </a:ext>
                </a:extLst>
              </a:tr>
              <a:tr h="358991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IN" sz="1400" kern="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93.398 ± 0.36</a:t>
                      </a:r>
                      <a:endParaRPr lang="en-IN" sz="1400" kern="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90.462 ± 0.64</a:t>
                      </a:r>
                      <a:endParaRPr lang="en-IN" sz="1400" kern="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92.516 ± 0.33</a:t>
                      </a:r>
                      <a:endParaRPr lang="en-IN" sz="1400" kern="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90.246 ± 0.63</a:t>
                      </a:r>
                      <a:endParaRPr lang="en-IN" sz="1400" kern="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95.382 ± 0.33</a:t>
                      </a:r>
                      <a:endParaRPr lang="en-IN" sz="1400" kern="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29172096"/>
                  </a:ext>
                </a:extLst>
              </a:tr>
              <a:tr h="358991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IN" sz="1400" kern="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00.834 ± 0.97</a:t>
                      </a:r>
                      <a:endParaRPr lang="en-IN" sz="1400" kern="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00.766 ± 0.65</a:t>
                      </a:r>
                      <a:endParaRPr lang="en-IN" sz="1400" kern="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01.746 ± 1.32</a:t>
                      </a:r>
                      <a:endParaRPr lang="en-IN" sz="1400" kern="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03.292 ± 1.27</a:t>
                      </a:r>
                      <a:endParaRPr lang="en-IN" sz="1400" kern="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03.042 ± 0.87</a:t>
                      </a:r>
                      <a:endParaRPr lang="en-IN" sz="1400" kern="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74438243"/>
                  </a:ext>
                </a:extLst>
              </a:tr>
              <a:tr h="358991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4</a:t>
                      </a:r>
                      <a:endParaRPr lang="en-IN" sz="1400" kern="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13.494 ± 0.6</a:t>
                      </a:r>
                      <a:endParaRPr lang="en-IN" sz="1400" kern="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15.176 ± 1.01</a:t>
                      </a:r>
                      <a:endParaRPr lang="en-IN" sz="1400" kern="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14.878 ± 1.2</a:t>
                      </a:r>
                      <a:endParaRPr lang="en-IN" sz="1400" kern="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12.330 ± 1.77</a:t>
                      </a:r>
                      <a:endParaRPr lang="en-IN" sz="1400" kern="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14.784 ± 1.28</a:t>
                      </a:r>
                      <a:endParaRPr lang="en-IN" sz="1400" kern="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34856354"/>
                  </a:ext>
                </a:extLst>
              </a:tr>
              <a:tr h="358991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1</a:t>
                      </a:r>
                      <a:endParaRPr lang="en-IN" sz="1400" kern="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23.948 ± 0.59</a:t>
                      </a:r>
                      <a:endParaRPr lang="en-IN" sz="1400" kern="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23.446 ± 1.36</a:t>
                      </a:r>
                      <a:endParaRPr lang="en-IN" sz="1400" kern="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24.178 ± 0.62</a:t>
                      </a:r>
                      <a:endParaRPr lang="en-IN" sz="1400" kern="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25.232 ± 1.38</a:t>
                      </a:r>
                      <a:endParaRPr lang="en-IN" sz="1400" kern="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22.712 ± 0.9</a:t>
                      </a:r>
                      <a:endParaRPr lang="en-IN" sz="1400" kern="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756807985"/>
                  </a:ext>
                </a:extLst>
              </a:tr>
              <a:tr h="358991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lang="en-IN" sz="1400" kern="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32.930 ± 0.88</a:t>
                      </a:r>
                      <a:endParaRPr lang="en-IN" sz="1400" kern="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32.162 ± 1.04</a:t>
                      </a:r>
                      <a:endParaRPr lang="en-IN" sz="1400" kern="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33.924 ± 0.99</a:t>
                      </a:r>
                      <a:endParaRPr lang="en-IN" sz="1400" kern="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34.986 ± 1.26</a:t>
                      </a:r>
                      <a:endParaRPr lang="en-IN" sz="1400" kern="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34.150 ± 1.08</a:t>
                      </a:r>
                      <a:endParaRPr lang="en-IN" sz="1400" kern="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30046802"/>
                  </a:ext>
                </a:extLst>
              </a:tr>
              <a:tr h="358991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5</a:t>
                      </a:r>
                      <a:endParaRPr lang="en-IN" sz="1400" kern="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en-IN" sz="1400" kern="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en-IN" sz="1400" kern="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en-IN" sz="1400" kern="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46.152 ± 1.58</a:t>
                      </a:r>
                      <a:endParaRPr lang="en-IN" sz="1400" kern="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45.714 ± 1.37</a:t>
                      </a:r>
                      <a:endParaRPr lang="en-IN" sz="1400" kern="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87035310"/>
                  </a:ext>
                </a:extLst>
              </a:tr>
              <a:tr h="358991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42</a:t>
                      </a:r>
                      <a:endParaRPr lang="en-IN" sz="1400" kern="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en-IN" sz="1400" kern="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en-IN" sz="1400" kern="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en-IN" sz="1400" kern="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54.798 ± 1.98</a:t>
                      </a:r>
                      <a:endParaRPr lang="en-IN" sz="1400" kern="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57.492 ± 1.11</a:t>
                      </a:r>
                      <a:endParaRPr lang="en-IN" sz="1400" kern="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94893539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CB19D4F1-BA5F-9851-87E8-B3DDA7603D8A}"/>
              </a:ext>
            </a:extLst>
          </p:cNvPr>
          <p:cNvSpPr txBox="1"/>
          <p:nvPr/>
        </p:nvSpPr>
        <p:spPr>
          <a:xfrm>
            <a:off x="417250" y="561077"/>
            <a:ext cx="11052699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b="1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2: </a:t>
            </a:r>
            <a:r>
              <a:rPr lang="en-IN" sz="15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ffect of sub-acute toxicity of orally administered BCS3 on body weight of normal Wistar rats.</a:t>
            </a:r>
            <a:endParaRPr lang="en-IN" sz="1500" kern="100" dirty="0">
              <a:effectLst/>
              <a:latin typeface="Palatino Linotype" panose="0204050205050503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DBB0321-1D65-AEAB-A7AA-8E92F3E1E019}"/>
              </a:ext>
            </a:extLst>
          </p:cNvPr>
          <p:cNvSpPr txBox="1"/>
          <p:nvPr/>
        </p:nvSpPr>
        <p:spPr>
          <a:xfrm>
            <a:off x="1305019" y="3970057"/>
            <a:ext cx="977431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200" kern="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ach value represents </a:t>
            </a:r>
            <a:r>
              <a:rPr lang="en-IN" sz="1200" kern="100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an±SEM</a:t>
            </a:r>
            <a:r>
              <a:rPr lang="en-IN" sz="1200" kern="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(n=5); comparisons: Groups II, III, IV and V compared to group I; (n=5). Each value shows ***</a:t>
            </a:r>
            <a:r>
              <a:rPr lang="en-IN" sz="1200" i="1" kern="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IN" sz="1200" kern="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&lt;0.001; **</a:t>
            </a:r>
            <a:r>
              <a:rPr lang="en-IN" sz="1200" i="1" kern="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IN" sz="1200" kern="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&lt;0.01; *</a:t>
            </a:r>
            <a:r>
              <a:rPr lang="en-IN" sz="1200" i="1" kern="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IN" sz="1200" kern="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&lt;0.05; </a:t>
            </a:r>
            <a:r>
              <a:rPr lang="en-IN" sz="1200" kern="100" baseline="30000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s</a:t>
            </a:r>
            <a:r>
              <a:rPr lang="en-IN" sz="1200" i="1" kern="100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IN" sz="1200" kern="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&gt;0.05; Sub-acute studies (repeated doses for 28 days): Group I: Vehicle control group; Group II: 30mg/kg BCS3; Group III: 300mg/kg BCS3; Group IV: Satellite control group (42 days) and Group V: 300mg/kg BCS3 (Satellite group: 42 days); n=5/group.</a:t>
            </a:r>
          </a:p>
        </p:txBody>
      </p:sp>
    </p:spTree>
    <p:extLst>
      <p:ext uri="{BB962C8B-B14F-4D97-AF65-F5344CB8AC3E}">
        <p14:creationId xmlns:p14="http://schemas.microsoft.com/office/powerpoint/2010/main" val="263582414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B339E9DB-A208-A342-AF6B-359B4273C54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16535191"/>
              </p:ext>
            </p:extLst>
          </p:nvPr>
        </p:nvGraphicFramePr>
        <p:xfrm>
          <a:off x="816746" y="751365"/>
          <a:ext cx="10218198" cy="5599626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955156">
                  <a:extLst>
                    <a:ext uri="{9D8B030D-6E8A-4147-A177-3AD203B41FA5}">
                      <a16:colId xmlns:a16="http://schemas.microsoft.com/office/drawing/2014/main" val="3922004302"/>
                    </a:ext>
                  </a:extLst>
                </a:gridCol>
                <a:gridCol w="1685560">
                  <a:extLst>
                    <a:ext uri="{9D8B030D-6E8A-4147-A177-3AD203B41FA5}">
                      <a16:colId xmlns:a16="http://schemas.microsoft.com/office/drawing/2014/main" val="3357057352"/>
                    </a:ext>
                  </a:extLst>
                </a:gridCol>
                <a:gridCol w="1748925">
                  <a:extLst>
                    <a:ext uri="{9D8B030D-6E8A-4147-A177-3AD203B41FA5}">
                      <a16:colId xmlns:a16="http://schemas.microsoft.com/office/drawing/2014/main" val="908792812"/>
                    </a:ext>
                  </a:extLst>
                </a:gridCol>
                <a:gridCol w="1562283">
                  <a:extLst>
                    <a:ext uri="{9D8B030D-6E8A-4147-A177-3AD203B41FA5}">
                      <a16:colId xmlns:a16="http://schemas.microsoft.com/office/drawing/2014/main" val="1387668878"/>
                    </a:ext>
                  </a:extLst>
                </a:gridCol>
                <a:gridCol w="1633713">
                  <a:extLst>
                    <a:ext uri="{9D8B030D-6E8A-4147-A177-3AD203B41FA5}">
                      <a16:colId xmlns:a16="http://schemas.microsoft.com/office/drawing/2014/main" val="2295583267"/>
                    </a:ext>
                  </a:extLst>
                </a:gridCol>
                <a:gridCol w="1632561">
                  <a:extLst>
                    <a:ext uri="{9D8B030D-6E8A-4147-A177-3AD203B41FA5}">
                      <a16:colId xmlns:a16="http://schemas.microsoft.com/office/drawing/2014/main" val="1397502891"/>
                    </a:ext>
                  </a:extLst>
                </a:gridCol>
              </a:tblGrid>
              <a:tr h="10980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IN" sz="12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500" b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Group I</a:t>
                      </a:r>
                      <a:endParaRPr lang="en-IN" sz="1500" b="1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500" b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Group II</a:t>
                      </a:r>
                      <a:endParaRPr lang="en-IN" sz="1500" b="1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500" b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Group III</a:t>
                      </a:r>
                      <a:endParaRPr lang="en-IN" sz="1500" b="1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500" b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Group IV</a:t>
                      </a:r>
                      <a:endParaRPr lang="en-IN" sz="1500" b="1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500" b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Group V</a:t>
                      </a:r>
                      <a:endParaRPr lang="en-IN" sz="1500" b="1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extLst>
                  <a:ext uri="{0D108BD9-81ED-4DB2-BD59-A6C34878D82A}">
                    <a16:rowId xmlns:a16="http://schemas.microsoft.com/office/drawing/2014/main" val="1736897170"/>
                  </a:ext>
                </a:extLst>
              </a:tr>
              <a:tr h="272282">
                <a:tc gridSpan="6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i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a) Hematological parameters</a:t>
                      </a:r>
                      <a:endParaRPr lang="en-IN" sz="1200" b="1" i="1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93833029"/>
                  </a:ext>
                </a:extLst>
              </a:tr>
              <a:tr h="350743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IN" sz="1400" b="1" i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Haemoglobin (g/dL)</a:t>
                      </a: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2.538 ± 0.105</a:t>
                      </a:r>
                      <a:endParaRPr lang="en-IN" sz="14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2.712 ± 0.080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2.891 ± 0.193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2.876 ± 0.125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2.644 ± 0.128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extLst>
                  <a:ext uri="{0D108BD9-81ED-4DB2-BD59-A6C34878D82A}">
                    <a16:rowId xmlns:a16="http://schemas.microsoft.com/office/drawing/2014/main" val="1653766130"/>
                  </a:ext>
                </a:extLst>
              </a:tr>
              <a:tr h="68276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IN" sz="1400" b="1" i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RBC </a:t>
                      </a: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IN" sz="1400" b="1" i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x106 cells/mm3)</a:t>
                      </a: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.074 ± 0.222</a:t>
                      </a:r>
                      <a:endParaRPr lang="en-IN" sz="14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.998 ± 0.186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.880 ± 0.120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.790 ± 0.204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.926 ± 0.071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extLst>
                  <a:ext uri="{0D108BD9-81ED-4DB2-BD59-A6C34878D82A}">
                    <a16:rowId xmlns:a16="http://schemas.microsoft.com/office/drawing/2014/main" val="2364686991"/>
                  </a:ext>
                </a:extLst>
              </a:tr>
              <a:tr h="68276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IN" sz="1400" b="1" i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WBC </a:t>
                      </a: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IN" sz="1400" b="1" i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x103 cells/mm3)</a:t>
                      </a: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.392 ± 0.060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.454 ± 0.062</a:t>
                      </a:r>
                      <a:endParaRPr lang="en-IN" sz="14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.800 ± 0.125</a:t>
                      </a:r>
                      <a:endParaRPr lang="en-IN" sz="14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.598 ± 0.134</a:t>
                      </a:r>
                      <a:endParaRPr lang="en-IN" sz="14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.384 ± 0.049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extLst>
                  <a:ext uri="{0D108BD9-81ED-4DB2-BD59-A6C34878D82A}">
                    <a16:rowId xmlns:a16="http://schemas.microsoft.com/office/drawing/2014/main" val="1897641181"/>
                  </a:ext>
                </a:extLst>
              </a:tr>
              <a:tr h="68276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IN" sz="1400" b="1" i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latelets </a:t>
                      </a: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IN" sz="1400" b="1" i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x103 cells/mm3)</a:t>
                      </a: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65.704 ± 1.396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65.210 ± 0.825</a:t>
                      </a:r>
                      <a:endParaRPr lang="en-IN" sz="14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68.646 ± 6.565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63.020 ± 6.007</a:t>
                      </a:r>
                      <a:endParaRPr lang="en-IN" sz="14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64.83 ± 1.539</a:t>
                      </a:r>
                      <a:endParaRPr lang="en-IN" sz="14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extLst>
                  <a:ext uri="{0D108BD9-81ED-4DB2-BD59-A6C34878D82A}">
                    <a16:rowId xmlns:a16="http://schemas.microsoft.com/office/drawing/2014/main" val="537597246"/>
                  </a:ext>
                </a:extLst>
              </a:tr>
              <a:tr h="350743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IN" sz="1400" b="1" i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Lymphocytes (109/L)</a:t>
                      </a: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9.380 ± 0.121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9.526 ± 0.069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9.104 ± 0.225</a:t>
                      </a:r>
                      <a:endParaRPr lang="en-IN" sz="14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9.500 ± 0.278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0.616 ± 0.431</a:t>
                      </a:r>
                      <a:endParaRPr lang="en-IN" sz="14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extLst>
                  <a:ext uri="{0D108BD9-81ED-4DB2-BD59-A6C34878D82A}">
                    <a16:rowId xmlns:a16="http://schemas.microsoft.com/office/drawing/2014/main" val="3728150125"/>
                  </a:ext>
                </a:extLst>
              </a:tr>
              <a:tr h="272282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IN" sz="1400" b="1" i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eutrophils (109/L)</a:t>
                      </a: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966 ± 0.022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948 ± 0.021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920 ± 0.029</a:t>
                      </a:r>
                      <a:endParaRPr lang="en-IN" sz="14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968 ± 0.008</a:t>
                      </a:r>
                      <a:endParaRPr lang="en-IN" sz="14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962 ± 0.020</a:t>
                      </a:r>
                      <a:endParaRPr lang="en-IN" sz="14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extLst>
                  <a:ext uri="{0D108BD9-81ED-4DB2-BD59-A6C34878D82A}">
                    <a16:rowId xmlns:a16="http://schemas.microsoft.com/office/drawing/2014/main" val="715254569"/>
                  </a:ext>
                </a:extLst>
              </a:tr>
              <a:tr h="272282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IN" sz="1400" b="1" i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Monocytes (109/L)</a:t>
                      </a: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172 ± 0.007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166 ± 0.008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177 ± 0.006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173 ± 0.003</a:t>
                      </a:r>
                      <a:endParaRPr lang="en-IN" sz="14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168 ± 0.006</a:t>
                      </a:r>
                      <a:endParaRPr lang="en-IN" sz="14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extLst>
                  <a:ext uri="{0D108BD9-81ED-4DB2-BD59-A6C34878D82A}">
                    <a16:rowId xmlns:a16="http://schemas.microsoft.com/office/drawing/2014/main" val="3574574827"/>
                  </a:ext>
                </a:extLst>
              </a:tr>
              <a:tr h="272282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IN" sz="1400" b="1" i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Eosinophils (109/L)</a:t>
                      </a: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85 ± 0.002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85 ± 0.001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86 ± 0.004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87 ± 0.003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85 ± 0.002</a:t>
                      </a:r>
                      <a:endParaRPr lang="en-IN" sz="14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extLst>
                  <a:ext uri="{0D108BD9-81ED-4DB2-BD59-A6C34878D82A}">
                    <a16:rowId xmlns:a16="http://schemas.microsoft.com/office/drawing/2014/main" val="660948884"/>
                  </a:ext>
                </a:extLst>
              </a:tr>
              <a:tr h="272282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IN" sz="1400" b="1" i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Basophils (109/L)</a:t>
                      </a: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66 ± 0.002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67 ± 0.003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68 ± 0.003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69 ± 0.002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69 ± 0.002</a:t>
                      </a:r>
                      <a:endParaRPr lang="en-IN" sz="14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extLst>
                  <a:ext uri="{0D108BD9-81ED-4DB2-BD59-A6C34878D82A}">
                    <a16:rowId xmlns:a16="http://schemas.microsoft.com/office/drawing/2014/main" val="2838949006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82C7DC4E-0045-8AB0-4B8B-A6F44CDC626B}"/>
              </a:ext>
            </a:extLst>
          </p:cNvPr>
          <p:cNvSpPr txBox="1"/>
          <p:nvPr/>
        </p:nvSpPr>
        <p:spPr>
          <a:xfrm>
            <a:off x="816746" y="291288"/>
            <a:ext cx="10564427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500" b="1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3: </a:t>
            </a:r>
            <a:r>
              <a:rPr lang="en-IN" sz="15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b-acute toxicity of orally administered BCS3 on haematological and biochemical parameters of Wistar rats.</a:t>
            </a:r>
            <a:endParaRPr lang="en-IN" sz="1500" kern="100" dirty="0">
              <a:effectLst/>
              <a:latin typeface="Palatino Linotype" panose="0204050205050503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endParaRPr lang="en-IN" sz="1500" dirty="0"/>
          </a:p>
        </p:txBody>
      </p:sp>
    </p:spTree>
    <p:extLst>
      <p:ext uri="{BB962C8B-B14F-4D97-AF65-F5344CB8AC3E}">
        <p14:creationId xmlns:p14="http://schemas.microsoft.com/office/powerpoint/2010/main" val="308634152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047B6597-54EB-33A0-CDB8-CA881135DC6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44784791"/>
              </p:ext>
            </p:extLst>
          </p:nvPr>
        </p:nvGraphicFramePr>
        <p:xfrm>
          <a:off x="838200" y="1426130"/>
          <a:ext cx="10218198" cy="2204088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955156">
                  <a:extLst>
                    <a:ext uri="{9D8B030D-6E8A-4147-A177-3AD203B41FA5}">
                      <a16:colId xmlns:a16="http://schemas.microsoft.com/office/drawing/2014/main" val="1342493682"/>
                    </a:ext>
                  </a:extLst>
                </a:gridCol>
                <a:gridCol w="1685560">
                  <a:extLst>
                    <a:ext uri="{9D8B030D-6E8A-4147-A177-3AD203B41FA5}">
                      <a16:colId xmlns:a16="http://schemas.microsoft.com/office/drawing/2014/main" val="2625487216"/>
                    </a:ext>
                  </a:extLst>
                </a:gridCol>
                <a:gridCol w="1748925">
                  <a:extLst>
                    <a:ext uri="{9D8B030D-6E8A-4147-A177-3AD203B41FA5}">
                      <a16:colId xmlns:a16="http://schemas.microsoft.com/office/drawing/2014/main" val="2575112412"/>
                    </a:ext>
                  </a:extLst>
                </a:gridCol>
                <a:gridCol w="1562283">
                  <a:extLst>
                    <a:ext uri="{9D8B030D-6E8A-4147-A177-3AD203B41FA5}">
                      <a16:colId xmlns:a16="http://schemas.microsoft.com/office/drawing/2014/main" val="1265710282"/>
                    </a:ext>
                  </a:extLst>
                </a:gridCol>
                <a:gridCol w="1633713">
                  <a:extLst>
                    <a:ext uri="{9D8B030D-6E8A-4147-A177-3AD203B41FA5}">
                      <a16:colId xmlns:a16="http://schemas.microsoft.com/office/drawing/2014/main" val="3759166869"/>
                    </a:ext>
                  </a:extLst>
                </a:gridCol>
                <a:gridCol w="1632561">
                  <a:extLst>
                    <a:ext uri="{9D8B030D-6E8A-4147-A177-3AD203B41FA5}">
                      <a16:colId xmlns:a16="http://schemas.microsoft.com/office/drawing/2014/main" val="1055761814"/>
                    </a:ext>
                  </a:extLst>
                </a:gridCol>
              </a:tblGrid>
              <a:tr h="272282">
                <a:tc gridSpan="6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i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b) Biochemical parameters</a:t>
                      </a:r>
                      <a:endParaRPr lang="en-IN" sz="1400" b="1" i="1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55807932"/>
                  </a:ext>
                </a:extLst>
              </a:tr>
              <a:tr h="272282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IN" sz="1400" b="1" i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AST (U/L)</a:t>
                      </a: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7.566 ± 2.076</a:t>
                      </a:r>
                      <a:endParaRPr lang="en-IN" sz="14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9.184 ± 1.487</a:t>
                      </a:r>
                      <a:endParaRPr lang="en-IN" sz="14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93.612 ± 0.932*</a:t>
                      </a:r>
                      <a:endParaRPr lang="en-IN" sz="14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6.388 ± 1.276</a:t>
                      </a:r>
                      <a:endParaRPr lang="en-IN" sz="14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8.206 ± 2.548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extLst>
                  <a:ext uri="{0D108BD9-81ED-4DB2-BD59-A6C34878D82A}">
                    <a16:rowId xmlns:a16="http://schemas.microsoft.com/office/drawing/2014/main" val="4231073237"/>
                  </a:ext>
                </a:extLst>
              </a:tr>
              <a:tr h="350743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IN" sz="1400" b="1" i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ALT (U/L)</a:t>
                      </a: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3.902 ± 2.990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3.432 ± 2.819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8.956 ± 1.333**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5.032 ± 1.414</a:t>
                      </a:r>
                      <a:endParaRPr lang="en-IN" sz="14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3.314 ± 2.769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extLst>
                  <a:ext uri="{0D108BD9-81ED-4DB2-BD59-A6C34878D82A}">
                    <a16:rowId xmlns:a16="http://schemas.microsoft.com/office/drawing/2014/main" val="505060809"/>
                  </a:ext>
                </a:extLst>
              </a:tr>
              <a:tr h="350743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IN" sz="1400" b="1" i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ALP (U/L)</a:t>
                      </a: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5.660 ± 1.830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5.600 ± 2.029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85.106 ± 1.408**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6.520 ± 1.046</a:t>
                      </a:r>
                      <a:endParaRPr lang="en-IN" sz="14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0.050 ± 0.617</a:t>
                      </a:r>
                      <a:endParaRPr lang="en-IN" sz="14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extLst>
                  <a:ext uri="{0D108BD9-81ED-4DB2-BD59-A6C34878D82A}">
                    <a16:rowId xmlns:a16="http://schemas.microsoft.com/office/drawing/2014/main" val="1828983323"/>
                  </a:ext>
                </a:extLst>
              </a:tr>
              <a:tr h="350743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IN" sz="1400" b="1" i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LDH (U/L)</a:t>
                      </a: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30.640 ± 1.967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30.794 ± 7.479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42.854 ± 2.830**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31.662 ± 1.542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31.868 ± 1.591</a:t>
                      </a:r>
                      <a:endParaRPr lang="en-IN" sz="14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extLst>
                  <a:ext uri="{0D108BD9-81ED-4DB2-BD59-A6C34878D82A}">
                    <a16:rowId xmlns:a16="http://schemas.microsoft.com/office/drawing/2014/main" val="3772763146"/>
                  </a:ext>
                </a:extLst>
              </a:tr>
              <a:tr h="272282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IN" sz="1400" b="1" i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GGT (U/L)</a:t>
                      </a: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5.638 ± 7.774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5.214 ± 0.495</a:t>
                      </a:r>
                      <a:endParaRPr lang="en-IN" sz="14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45.036 ± 1.161*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4.910 ± 1.346</a:t>
                      </a:r>
                      <a:endParaRPr lang="en-IN" sz="140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6.090 ± 1.037</a:t>
                      </a:r>
                      <a:endParaRPr lang="en-IN" sz="14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379" marR="45379" marT="0" marB="0"/>
                </a:tc>
                <a:extLst>
                  <a:ext uri="{0D108BD9-81ED-4DB2-BD59-A6C34878D82A}">
                    <a16:rowId xmlns:a16="http://schemas.microsoft.com/office/drawing/2014/main" val="3328194002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7886B9D0-51BF-B5DD-F37D-F50BAEFD003D}"/>
              </a:ext>
            </a:extLst>
          </p:cNvPr>
          <p:cNvSpPr txBox="1"/>
          <p:nvPr/>
        </p:nvSpPr>
        <p:spPr>
          <a:xfrm>
            <a:off x="838200" y="3641078"/>
            <a:ext cx="10218198" cy="10720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IN" sz="1200" kern="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ach value represents </a:t>
            </a:r>
            <a:r>
              <a:rPr lang="en-IN" sz="1200" kern="100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an±SEM</a:t>
            </a:r>
            <a:r>
              <a:rPr lang="en-IN" sz="1200" kern="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(n=5); comparisons: Groups II, III, IV and V compared to group I; (n=5). Each value shows ***</a:t>
            </a:r>
            <a:r>
              <a:rPr lang="en-IN" sz="1200" i="1" kern="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IN" sz="1200" kern="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&lt;0.001; **</a:t>
            </a:r>
            <a:r>
              <a:rPr lang="en-IN" sz="1200" i="1" kern="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IN" sz="1200" kern="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&lt;0.01; *</a:t>
            </a:r>
            <a:r>
              <a:rPr lang="en-IN" sz="1200" i="1" kern="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IN" sz="1200" kern="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&lt;0.05; </a:t>
            </a:r>
            <a:r>
              <a:rPr lang="en-IN" sz="1200" kern="100" baseline="30000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s</a:t>
            </a:r>
            <a:r>
              <a:rPr lang="en-IN" sz="1200" i="1" kern="100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IN" sz="1200" kern="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&gt;0.05; Sub-acute studies (repeated doses for 28 days): Group I: Vehicle control group; Group II: 30mg/kg BCS3; Group III: 300mg/kg BCS3; Group IV: Satellite control group (42 days) and Group V: 300mg/kg BCS3 (Satellite group: 42 days); n=5/group. RBC: Red blood cells; WBC: White blood cells; AST: Aspartate transaminase; ALT: Alanine transaminase; ALP: Alkaline phosphatase; L</a:t>
            </a:r>
            <a:r>
              <a:rPr lang="en-US" sz="12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H:</a:t>
            </a:r>
            <a:r>
              <a:rPr lang="en-US" sz="1200" b="1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actate dehydrogenase; GGT: Gamma-glutamyl</a:t>
            </a:r>
            <a:r>
              <a:rPr lang="en-US" sz="1200" b="1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ranspeptidase.</a:t>
            </a:r>
            <a:endParaRPr lang="en-IN" sz="1200" kern="100" dirty="0">
              <a:effectLst/>
              <a:latin typeface="Palatino Linotype" panose="0204050205050503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7DE72B5-0BB1-E901-551A-FB1CEE72A660}"/>
              </a:ext>
            </a:extLst>
          </p:cNvPr>
          <p:cNvSpPr txBox="1"/>
          <p:nvPr/>
        </p:nvSpPr>
        <p:spPr>
          <a:xfrm>
            <a:off x="550416" y="872132"/>
            <a:ext cx="1104382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500" b="1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2 (cont.): </a:t>
            </a:r>
            <a:r>
              <a:rPr lang="en-IN" sz="15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b-acute toxicity of orally administered BCS3 on haematological and biochemical parameters of Wistar rats.</a:t>
            </a:r>
            <a:endParaRPr lang="en-IN" sz="1500" kern="100" dirty="0">
              <a:effectLst/>
              <a:latin typeface="Palatino Linotype" panose="0204050205050503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endParaRPr lang="en-IN" sz="1500" dirty="0"/>
          </a:p>
        </p:txBody>
      </p:sp>
    </p:spTree>
    <p:extLst>
      <p:ext uri="{BB962C8B-B14F-4D97-AF65-F5344CB8AC3E}">
        <p14:creationId xmlns:p14="http://schemas.microsoft.com/office/powerpoint/2010/main" val="14330263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82A2D779-E1E1-B45F-1183-482BD107E01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19245503"/>
              </p:ext>
            </p:extLst>
          </p:nvPr>
        </p:nvGraphicFramePr>
        <p:xfrm>
          <a:off x="857681" y="609083"/>
          <a:ext cx="10476638" cy="6085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614038">
                  <a:extLst>
                    <a:ext uri="{9D8B030D-6E8A-4147-A177-3AD203B41FA5}">
                      <a16:colId xmlns:a16="http://schemas.microsoft.com/office/drawing/2014/main" val="1735351563"/>
                    </a:ext>
                  </a:extLst>
                </a:gridCol>
                <a:gridCol w="8862600">
                  <a:extLst>
                    <a:ext uri="{9D8B030D-6E8A-4147-A177-3AD203B41FA5}">
                      <a16:colId xmlns:a16="http://schemas.microsoft.com/office/drawing/2014/main" val="3381322610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Figure S1</a:t>
                      </a:r>
                      <a:endParaRPr lang="en-IN" sz="14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IN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Design of an azomethine derivative, 1-(4-chlorophenyl)-N-(4-ethoxyphenyl)</a:t>
                      </a:r>
                      <a:r>
                        <a:rPr lang="en-IN" sz="1400" dirty="0" err="1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methanimine</a:t>
                      </a:r>
                      <a:r>
                        <a:rPr lang="en-IN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(BCS3), based on previously reported azomethines as potent cytotoxic agents (a) 3-[(3-methoxy-2-hydroxyphenyl)</a:t>
                      </a:r>
                      <a:r>
                        <a:rPr lang="en-IN" sz="1400" dirty="0" err="1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methylideneamino</a:t>
                      </a:r>
                      <a:r>
                        <a:rPr lang="en-IN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]benzoic acid, (b) 4-bromo-2-((pyrazin-2-ylimino)methyl)phenol and (c) 4-nitro-2-((pyrazin-2-ylimino)methyl)phenol. </a:t>
                      </a:r>
                      <a:r>
                        <a:rPr lang="en-IN" sz="1400" b="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Scheme I: </a:t>
                      </a:r>
                      <a:r>
                        <a:rPr lang="en-IN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Synthesis of BCS3</a:t>
                      </a:r>
                      <a:endParaRPr lang="en-IN" sz="14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4464157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Figure S2</a:t>
                      </a:r>
                      <a:endParaRPr lang="en-IN" sz="14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a) 3D structure of BCS3. (b) </a:t>
                      </a:r>
                      <a:r>
                        <a:rPr lang="en-IN" sz="14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</a:rPr>
                        <a:t>ESI mass spectrum of Azomethine derivative, BCS3 (</a:t>
                      </a:r>
                      <a:r>
                        <a:rPr lang="en-IN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</a:rPr>
                        <a:t>1-(4-chlorophenyl)-N-(4-ethoxyphenyl)</a:t>
                      </a:r>
                      <a:r>
                        <a:rPr lang="en-IN" sz="1400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</a:rPr>
                        <a:t>methanimine</a:t>
                      </a:r>
                      <a:r>
                        <a:rPr lang="en-IN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</a:rPr>
                        <a:t>)</a:t>
                      </a:r>
                      <a:endParaRPr lang="en-IN" sz="14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1092550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Figure S3</a:t>
                      </a:r>
                      <a:endParaRPr lang="en-IN" sz="14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IN" sz="14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</a:rPr>
                        <a:t>(a) </a:t>
                      </a:r>
                      <a:r>
                        <a:rPr lang="en-IN" sz="1400" baseline="30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</a:rPr>
                        <a:t>1</a:t>
                      </a:r>
                      <a:r>
                        <a:rPr lang="en-IN" sz="14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</a:rPr>
                        <a:t>HNMR, (b) </a:t>
                      </a:r>
                      <a:r>
                        <a:rPr lang="en-IN" sz="1400" baseline="30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</a:rPr>
                        <a:t>13</a:t>
                      </a:r>
                      <a:r>
                        <a:rPr lang="en-IN" sz="14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</a:rPr>
                        <a:t>CNMR, and (c) Fourier transform infrared spectra for BCS3</a:t>
                      </a:r>
                      <a:endParaRPr lang="en-IN" sz="14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0625927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Figure S4</a:t>
                      </a:r>
                      <a:endParaRPr lang="en-IN" sz="14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IN" sz="14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</a:rPr>
                        <a:t>HPLC chromatogram of BCS3</a:t>
                      </a:r>
                      <a:endParaRPr lang="en-IN" sz="14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1227881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Figure S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4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mparison of redocked pose of (a) </a:t>
                      </a:r>
                      <a:r>
                        <a:rPr lang="en-IN" sz="1400" kern="100" dirty="0">
                          <a:effectLst/>
                          <a:highlight>
                            <a:srgbClr val="FFFFFF"/>
                          </a:highlight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3S,6S,7S,9aS)-6-{[(2S)-2-aminobutanoyl]amino}-N-(</a:t>
                      </a:r>
                      <a:r>
                        <a:rPr lang="en-IN" sz="1400" kern="100" dirty="0" err="1">
                          <a:effectLst/>
                          <a:highlight>
                            <a:srgbClr val="FFFFFF"/>
                          </a:highlight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iphenylmethyl</a:t>
                      </a:r>
                      <a:r>
                        <a:rPr lang="en-IN" sz="1400" kern="100" dirty="0">
                          <a:effectLst/>
                          <a:highlight>
                            <a:srgbClr val="FFFFFF"/>
                          </a:highlight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-7 (hydroxymethyl)-5-oxooctahydro-1H-pyrrolo[1,2-a]azepine-3-carboxamide into binding site </a:t>
                      </a:r>
                      <a:r>
                        <a:rPr lang="en-IN" sz="1400" kern="100" dirty="0">
                          <a:highlight>
                            <a:srgbClr val="FFFFFF"/>
                          </a:highlight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f XIAP (PDB code: 3CLX) and (b) </a:t>
                      </a:r>
                      <a:r>
                        <a:rPr lang="en-IN" sz="1400" dirty="0">
                          <a:effectLst/>
                          <a:highlight>
                            <a:srgbClr val="FFFFFF"/>
                          </a:highlight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3S,6S,7R,9aS)-6-{[(2S)-2-aminobutanoyl]amino}-7-(2-aminoethyl)-N-(</a:t>
                      </a:r>
                      <a:r>
                        <a:rPr lang="en-IN" sz="1400" dirty="0" err="1">
                          <a:effectLst/>
                          <a:highlight>
                            <a:srgbClr val="FFFFFF"/>
                          </a:highlight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iphenylmethyl</a:t>
                      </a:r>
                      <a:r>
                        <a:rPr lang="en-IN" sz="1400" dirty="0">
                          <a:effectLst/>
                          <a:highlight>
                            <a:srgbClr val="FFFFFF"/>
                          </a:highlight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-5-oxooctahydro-1H-pyrrolo[1,2-a]azepine-3-carboxamide into the binding site of cIAP1 (PDB code: 3MUP) with their native co-crystallized poses respectively. The close-</a:t>
                      </a:r>
                      <a:r>
                        <a:rPr lang="en-IN" sz="1400" dirty="0">
                          <a:highlight>
                            <a:srgbClr val="FFFFFF"/>
                          </a:highlight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up views of two ligands show the confirmation of the redocked ligand (blue </a:t>
                      </a:r>
                      <a:r>
                        <a:rPr lang="en-IN" sz="1400" dirty="0" err="1">
                          <a:highlight>
                            <a:srgbClr val="FFFFFF"/>
                          </a:highlight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lor</a:t>
                      </a:r>
                      <a:r>
                        <a:rPr lang="en-IN" sz="1400" dirty="0">
                          <a:highlight>
                            <a:srgbClr val="FFFFFF"/>
                          </a:highlight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 compared to co-crystallized one (red </a:t>
                      </a:r>
                      <a:r>
                        <a:rPr lang="en-IN" sz="1400" dirty="0" err="1">
                          <a:highlight>
                            <a:srgbClr val="FFFFFF"/>
                          </a:highlight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lor</a:t>
                      </a:r>
                      <a:r>
                        <a:rPr lang="en-IN" sz="1400" dirty="0">
                          <a:highlight>
                            <a:srgbClr val="FFFFFF"/>
                          </a:highlight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IN" sz="1400" kern="1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0843110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Table S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4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</a:rPr>
                        <a:t>Binding interactions of BCS1-4 and the reference co-crystal ligands with the inhibitors of apoptosis proteins (IAPs).</a:t>
                      </a:r>
                      <a:endParaRPr lang="en-IN" sz="1400" kern="1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2113077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Figure S6</a:t>
                      </a:r>
                      <a:endParaRPr lang="en-IN" sz="14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IN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robable metabolites of BCS3 (M1-M9) after biotransformation through Phase I (CYP450) transformation predicted by using </a:t>
                      </a:r>
                      <a:r>
                        <a:rPr lang="en-IN" sz="1400" dirty="0" err="1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BioTransformer</a:t>
                      </a:r>
                      <a:r>
                        <a:rPr lang="en-IN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3.0 online software</a:t>
                      </a:r>
                      <a:endParaRPr lang="en-IN" sz="14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2732655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Figure S7</a:t>
                      </a:r>
                      <a:endParaRPr lang="en-IN" sz="14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IN" sz="14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Real Time Quantitative Polymerase Chain Reaction (RT-qPCR) of (a) Inhibition of apoptosis proteins, (b) Critical apoptotic proteins (c) Caspases and (d) Cell cycle proteins in MDA-MB-231 cells after treatment with BCS3 (0.8, 1.6 and 3.2 µM doses)</a:t>
                      </a:r>
                      <a:endParaRPr lang="en-IN" sz="14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6261516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Table S2</a:t>
                      </a:r>
                      <a:endParaRPr lang="en-IN" sz="14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IN" sz="1400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ffect of sub-acute toxicity of orally administered BCS3 on body weight of normal Wistar rats</a:t>
                      </a:r>
                      <a:endParaRPr lang="en-IN" sz="14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2595452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Table S3</a:t>
                      </a:r>
                      <a:endParaRPr lang="en-IN" sz="14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400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ub-acute toxicity of orally administered BCS3 on haematological and biochemical parameters of Wistar rats</a:t>
                      </a:r>
                      <a:endParaRPr lang="en-IN" sz="1400" kern="1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52359161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A0A1EA2F-4E00-D3C5-F339-6F73D1A50559}"/>
              </a:ext>
            </a:extLst>
          </p:cNvPr>
          <p:cNvSpPr txBox="1"/>
          <p:nvPr/>
        </p:nvSpPr>
        <p:spPr>
          <a:xfrm>
            <a:off x="178537" y="159301"/>
            <a:ext cx="11834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Table of contents</a:t>
            </a:r>
            <a:endParaRPr lang="en-IN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280715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0959E4BD-A737-8967-259B-6FEC3E97046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40728268"/>
              </p:ext>
            </p:extLst>
          </p:nvPr>
        </p:nvGraphicFramePr>
        <p:xfrm>
          <a:off x="2484737" y="53268"/>
          <a:ext cx="7222523" cy="59451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2" imgW="6493941" imgH="5678424" progId="ChemDraw.Document.6.0">
                  <p:embed/>
                </p:oleObj>
              </mc:Choice>
              <mc:Fallback>
                <p:oleObj name="CS ChemDraw Drawing" r:id="rId2" imgW="6493941" imgH="5678424" progId="ChemDraw.Document.6.0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0959E4BD-A737-8967-259B-6FEC3E97046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484737" y="53268"/>
                        <a:ext cx="7222523" cy="59451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DDE6EDF1-38E7-932C-2099-27376FCF5BAB}"/>
              </a:ext>
            </a:extLst>
          </p:cNvPr>
          <p:cNvSpPr txBox="1"/>
          <p:nvPr/>
        </p:nvSpPr>
        <p:spPr>
          <a:xfrm>
            <a:off x="298881" y="5998436"/>
            <a:ext cx="1159423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1. </a:t>
            </a:r>
            <a:r>
              <a:rPr lang="en-IN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Design of an azomethine derivative, 1-(4-chlorophenyl)-N-(4-ethoxyphenyl)</a:t>
            </a:r>
            <a:r>
              <a:rPr lang="en-IN" sz="14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methanimine</a:t>
            </a:r>
            <a:r>
              <a:rPr lang="en-IN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(BCS3), based on previously reported azomethines as potent cytotoxic agents (a) 3-[(3-methoxy-2-hydroxyphenyl)</a:t>
            </a:r>
            <a:r>
              <a:rPr lang="en-IN" sz="14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methylideneamino</a:t>
            </a:r>
            <a:r>
              <a:rPr lang="en-IN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]benzoic acid, (b) 4-bromo-2-((pyrazin-2-ylimino)methyl)phenol and (c) 4-nitro-2-((pyrazin-2-ylimino)methyl)phenol. </a:t>
            </a:r>
            <a:r>
              <a:rPr lang="en-IN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cheme I: </a:t>
            </a:r>
            <a:r>
              <a:rPr lang="en-IN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ynthesis of BCS3.</a:t>
            </a:r>
          </a:p>
        </p:txBody>
      </p:sp>
    </p:spTree>
    <p:extLst>
      <p:ext uri="{BB962C8B-B14F-4D97-AF65-F5344CB8AC3E}">
        <p14:creationId xmlns:p14="http://schemas.microsoft.com/office/powerpoint/2010/main" val="15238175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FFCD9979-AD49-9863-E68D-F64DA0FB175B}"/>
              </a:ext>
            </a:extLst>
          </p:cNvPr>
          <p:cNvGrpSpPr/>
          <p:nvPr/>
        </p:nvGrpSpPr>
        <p:grpSpPr>
          <a:xfrm>
            <a:off x="3045040" y="656949"/>
            <a:ext cx="7377344" cy="5131876"/>
            <a:chOff x="2006354" y="719091"/>
            <a:chExt cx="8158578" cy="5193437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C384278B-0B05-FB94-54F9-F786D506BE0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5" t="4258" r="674" b="1714"/>
            <a:stretch/>
          </p:blipFill>
          <p:spPr>
            <a:xfrm>
              <a:off x="2006354" y="719091"/>
              <a:ext cx="8158578" cy="5193437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684ED61-EFBE-B98D-0EE6-DD76A2016295}"/>
                </a:ext>
              </a:extLst>
            </p:cNvPr>
            <p:cNvSpPr txBox="1"/>
            <p:nvPr/>
          </p:nvSpPr>
          <p:spPr>
            <a:xfrm>
              <a:off x="6768382" y="1721405"/>
              <a:ext cx="1967640" cy="2591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act mass: 260.08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5525B6DF-C4B9-7D8B-C061-6926400C3A9E}"/>
              </a:ext>
            </a:extLst>
          </p:cNvPr>
          <p:cNvSpPr txBox="1"/>
          <p:nvPr/>
        </p:nvSpPr>
        <p:spPr>
          <a:xfrm>
            <a:off x="91736" y="6108112"/>
            <a:ext cx="118043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2. 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(a) 3D structure of BCS3. (b) </a:t>
            </a:r>
            <a:r>
              <a:rPr lang="en-IN" sz="1400" dirty="0"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ESI mass spectrum of Azomethine derivative, BCS3 (</a:t>
            </a:r>
            <a:r>
              <a:rPr lang="en-IN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1-(4-chlorophenyl)-N-(4-ethoxyphenyl)</a:t>
            </a:r>
            <a:r>
              <a:rPr lang="en-IN" sz="14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methanimine</a:t>
            </a:r>
            <a:r>
              <a:rPr lang="en-IN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).</a:t>
            </a:r>
            <a:endParaRPr lang="en-IN" sz="14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658EFC6-DC55-24AF-4E1E-D433C15C29F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90066044"/>
              </p:ext>
            </p:extLst>
          </p:nvPr>
        </p:nvGraphicFramePr>
        <p:xfrm>
          <a:off x="806106" y="1260760"/>
          <a:ext cx="2007431" cy="297041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3D XML" r:id="rId3" imgW="2621138" imgH="3878572" progId="Chem3D.Document.9">
                  <p:embed/>
                </p:oleObj>
              </mc:Choice>
              <mc:Fallback>
                <p:oleObj name="Chem3D XML" r:id="rId3" imgW="2621138" imgH="3878572" progId="Chem3D.Document.9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5BC125C8-3BA3-3205-2314-64FB964D319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06106" y="1260760"/>
                        <a:ext cx="2007431" cy="297041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D5A82764-1AA6-1BE0-12E2-F37B5DEB9149}"/>
              </a:ext>
            </a:extLst>
          </p:cNvPr>
          <p:cNvSpPr txBox="1"/>
          <p:nvPr/>
        </p:nvSpPr>
        <p:spPr>
          <a:xfrm>
            <a:off x="542051" y="3429000"/>
            <a:ext cx="7928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BE16D00-DE5B-ED47-2B2A-1B465D855536}"/>
              </a:ext>
            </a:extLst>
          </p:cNvPr>
          <p:cNvSpPr txBox="1"/>
          <p:nvPr/>
        </p:nvSpPr>
        <p:spPr>
          <a:xfrm>
            <a:off x="2648638" y="5150896"/>
            <a:ext cx="7928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77186D13-ACAF-60D4-121E-7E6FD4A01D4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1697308"/>
              </p:ext>
            </p:extLst>
          </p:nvPr>
        </p:nvGraphicFramePr>
        <p:xfrm>
          <a:off x="7204844" y="852772"/>
          <a:ext cx="2071687" cy="815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5" imgW="2071222" imgH="816564" progId="ChemDraw.Document.6.0">
                  <p:embed/>
                </p:oleObj>
              </mc:Choice>
              <mc:Fallback>
                <p:oleObj name="CS ChemDraw Drawing" r:id="rId5" imgW="2071222" imgH="816564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204844" y="852772"/>
                        <a:ext cx="2071687" cy="815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87985509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1121721B-079E-B1A4-4E90-B40E1CC3708B}"/>
              </a:ext>
            </a:extLst>
          </p:cNvPr>
          <p:cNvSpPr txBox="1"/>
          <p:nvPr/>
        </p:nvSpPr>
        <p:spPr>
          <a:xfrm>
            <a:off x="6056833" y="3473017"/>
            <a:ext cx="7928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FC5883AA-43C7-C206-D290-09C35D543F6B}"/>
              </a:ext>
            </a:extLst>
          </p:cNvPr>
          <p:cNvGrpSpPr/>
          <p:nvPr/>
        </p:nvGrpSpPr>
        <p:grpSpPr>
          <a:xfrm>
            <a:off x="1" y="41448"/>
            <a:ext cx="6232124" cy="3735999"/>
            <a:chOff x="1" y="41448"/>
            <a:chExt cx="6232124" cy="3735999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7A1B0231-A7D3-4791-98B4-0DBCF2C2EE0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" y="41448"/>
              <a:ext cx="6232124" cy="3735999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80A2059-5E4F-C1BD-E7CB-A1B1C3420E6B}"/>
                </a:ext>
              </a:extLst>
            </p:cNvPr>
            <p:cNvSpPr txBox="1"/>
            <p:nvPr/>
          </p:nvSpPr>
          <p:spPr>
            <a:xfrm>
              <a:off x="2543268" y="524638"/>
              <a:ext cx="350205" cy="2294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3FAF64BC-CBDB-A68E-D762-49764A9F60BB}"/>
                </a:ext>
              </a:extLst>
            </p:cNvPr>
            <p:cNvSpPr txBox="1"/>
            <p:nvPr/>
          </p:nvSpPr>
          <p:spPr>
            <a:xfrm>
              <a:off x="2368166" y="356634"/>
              <a:ext cx="350205" cy="2294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41613D6-72E2-4B53-FC10-58DF7D4A27F5}"/>
                </a:ext>
              </a:extLst>
            </p:cNvPr>
            <p:cNvSpPr txBox="1"/>
            <p:nvPr/>
          </p:nvSpPr>
          <p:spPr>
            <a:xfrm>
              <a:off x="1430923" y="92031"/>
              <a:ext cx="350205" cy="2294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C3796B7A-BA41-0DB8-8196-DF9B3D3EA51A}"/>
                </a:ext>
              </a:extLst>
            </p:cNvPr>
            <p:cNvSpPr txBox="1"/>
            <p:nvPr/>
          </p:nvSpPr>
          <p:spPr>
            <a:xfrm>
              <a:off x="2086656" y="315293"/>
              <a:ext cx="350205" cy="2294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704B7960-0625-1502-4480-897375A21C54}"/>
                </a:ext>
              </a:extLst>
            </p:cNvPr>
            <p:cNvSpPr txBox="1"/>
            <p:nvPr/>
          </p:nvSpPr>
          <p:spPr>
            <a:xfrm>
              <a:off x="1606025" y="598034"/>
              <a:ext cx="350205" cy="2294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969E8612-DB1C-1804-6FAC-870A63815452}"/>
                </a:ext>
              </a:extLst>
            </p:cNvPr>
            <p:cNvSpPr txBox="1"/>
            <p:nvPr/>
          </p:nvSpPr>
          <p:spPr>
            <a:xfrm>
              <a:off x="3803369" y="2121628"/>
              <a:ext cx="350205" cy="2294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9D68C137-01EB-ADF7-E5F7-83FC4B3BA906}"/>
                </a:ext>
              </a:extLst>
            </p:cNvPr>
            <p:cNvSpPr txBox="1"/>
            <p:nvPr/>
          </p:nvSpPr>
          <p:spPr>
            <a:xfrm>
              <a:off x="2706829" y="2414591"/>
              <a:ext cx="350205" cy="2294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C9ADCA56-F836-C46B-45FC-13E7B1DA9A89}"/>
                </a:ext>
              </a:extLst>
            </p:cNvPr>
            <p:cNvSpPr txBox="1"/>
            <p:nvPr/>
          </p:nvSpPr>
          <p:spPr>
            <a:xfrm>
              <a:off x="1279434" y="1998065"/>
              <a:ext cx="350205" cy="2294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2" name="Right Brace 1">
              <a:extLst>
                <a:ext uri="{FF2B5EF4-FFF2-40B4-BE49-F238E27FC236}">
                  <a16:creationId xmlns:a16="http://schemas.microsoft.com/office/drawing/2014/main" id="{4E8F7FC2-912E-3063-8AB9-35F2C0032136}"/>
                </a:ext>
              </a:extLst>
            </p:cNvPr>
            <p:cNvSpPr/>
            <p:nvPr/>
          </p:nvSpPr>
          <p:spPr>
            <a:xfrm rot="16200000">
              <a:off x="1416008" y="2005562"/>
              <a:ext cx="66134" cy="461605"/>
            </a:xfrm>
            <a:prstGeom prst="rightBrac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7C094497-2538-0392-E84F-C442B8280E63}"/>
                </a:ext>
              </a:extLst>
            </p:cNvPr>
            <p:cNvSpPr txBox="1"/>
            <p:nvPr/>
          </p:nvSpPr>
          <p:spPr>
            <a:xfrm>
              <a:off x="749381" y="2552959"/>
              <a:ext cx="350205" cy="2294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216A6996-92D2-899F-F658-6C976F6033BF}"/>
              </a:ext>
            </a:extLst>
          </p:cNvPr>
          <p:cNvGrpSpPr/>
          <p:nvPr/>
        </p:nvGrpSpPr>
        <p:grpSpPr>
          <a:xfrm>
            <a:off x="6096000" y="68081"/>
            <a:ext cx="6095999" cy="3815900"/>
            <a:chOff x="6096000" y="68081"/>
            <a:chExt cx="6095999" cy="3815900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4B065A16-19BF-B5D8-011B-640AC057763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96000" y="68081"/>
              <a:ext cx="6095999" cy="3815900"/>
            </a:xfrm>
            <a:prstGeom prst="rect">
              <a:avLst/>
            </a:prstGeom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9C1FFBF1-B469-AD29-0D3E-F9DC035323E5}"/>
                </a:ext>
              </a:extLst>
            </p:cNvPr>
            <p:cNvSpPr txBox="1"/>
            <p:nvPr/>
          </p:nvSpPr>
          <p:spPr>
            <a:xfrm>
              <a:off x="7824392" y="727480"/>
              <a:ext cx="56516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7.94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B398E277-04D8-E7A7-BDDC-0FB3B340A468}"/>
                </a:ext>
              </a:extLst>
            </p:cNvPr>
            <p:cNvSpPr txBox="1"/>
            <p:nvPr/>
          </p:nvSpPr>
          <p:spPr>
            <a:xfrm>
              <a:off x="8747949" y="486080"/>
              <a:ext cx="56516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3.6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3DE03A72-6940-70FF-6BE8-7D8491015D50}"/>
                </a:ext>
              </a:extLst>
            </p:cNvPr>
            <p:cNvSpPr txBox="1"/>
            <p:nvPr/>
          </p:nvSpPr>
          <p:spPr>
            <a:xfrm>
              <a:off x="8931842" y="676753"/>
              <a:ext cx="56516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.95</a:t>
              </a:r>
            </a:p>
          </p:txBody>
        </p:sp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id="{75A7FD65-5D44-7FA6-AD77-7E72E79E725B}"/>
              </a:ext>
            </a:extLst>
          </p:cNvPr>
          <p:cNvSpPr txBox="1"/>
          <p:nvPr/>
        </p:nvSpPr>
        <p:spPr>
          <a:xfrm>
            <a:off x="1279433" y="6216205"/>
            <a:ext cx="87700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3. </a:t>
            </a:r>
            <a:r>
              <a:rPr lang="en-IN" sz="1400" dirty="0"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(a) </a:t>
            </a:r>
            <a:r>
              <a:rPr lang="en-IN" sz="1400" baseline="30000" dirty="0"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1</a:t>
            </a:r>
            <a:r>
              <a:rPr lang="en-IN" sz="1400" dirty="0"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HNMR, (b) </a:t>
            </a:r>
            <a:r>
              <a:rPr lang="en-IN" sz="1400" baseline="30000" dirty="0"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13</a:t>
            </a:r>
            <a:r>
              <a:rPr lang="en-IN" sz="1400" dirty="0"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CNMR, and (c) Fourier transform infrared spectra for BCS3.</a:t>
            </a:r>
            <a:endParaRPr lang="en-IN" sz="14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75B8116-3B14-8C8F-3A2F-6A4DE9E1CDCC}"/>
              </a:ext>
            </a:extLst>
          </p:cNvPr>
          <p:cNvSpPr txBox="1"/>
          <p:nvPr/>
        </p:nvSpPr>
        <p:spPr>
          <a:xfrm>
            <a:off x="6056833" y="3473017"/>
            <a:ext cx="7928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29FDCF7-215E-60E3-29CF-A8AB9B127CA7}"/>
              </a:ext>
            </a:extLst>
          </p:cNvPr>
          <p:cNvSpPr txBox="1"/>
          <p:nvPr/>
        </p:nvSpPr>
        <p:spPr>
          <a:xfrm>
            <a:off x="-78333" y="3401986"/>
            <a:ext cx="7928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52B6E4B8-7A4F-40FB-79E7-71E6F9259FE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25782131"/>
              </p:ext>
            </p:extLst>
          </p:nvPr>
        </p:nvGraphicFramePr>
        <p:xfrm>
          <a:off x="1182800" y="178287"/>
          <a:ext cx="1648314" cy="6492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4" imgW="2071222" imgH="816564" progId="ChemDraw.Document.6.0">
                  <p:embed/>
                </p:oleObj>
              </mc:Choice>
              <mc:Fallback>
                <p:oleObj name="CS ChemDraw Drawing" r:id="rId4" imgW="2071222" imgH="816564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182800" y="178287"/>
                        <a:ext cx="1648314" cy="6492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701C168D-B547-841E-CBF1-F36C34E0CBB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77010435"/>
              </p:ext>
            </p:extLst>
          </p:nvPr>
        </p:nvGraphicFramePr>
        <p:xfrm>
          <a:off x="7414452" y="213968"/>
          <a:ext cx="1950218" cy="7681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6" imgW="2071222" imgH="816564" progId="ChemDraw.Document.6.0">
                  <p:embed/>
                </p:oleObj>
              </mc:Choice>
              <mc:Fallback>
                <p:oleObj name="CS ChemDraw Drawing" r:id="rId6" imgW="2071222" imgH="816564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7414452" y="213968"/>
                        <a:ext cx="1950218" cy="7681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31" name="Group 30">
            <a:extLst>
              <a:ext uri="{FF2B5EF4-FFF2-40B4-BE49-F238E27FC236}">
                <a16:creationId xmlns:a16="http://schemas.microsoft.com/office/drawing/2014/main" id="{250B468E-BC23-CBA4-FF56-D019618BDAB1}"/>
              </a:ext>
            </a:extLst>
          </p:cNvPr>
          <p:cNvGrpSpPr/>
          <p:nvPr/>
        </p:nvGrpSpPr>
        <p:grpSpPr>
          <a:xfrm>
            <a:off x="2565351" y="4304544"/>
            <a:ext cx="6198251" cy="1697306"/>
            <a:chOff x="2849725" y="4296792"/>
            <a:chExt cx="6198251" cy="1697306"/>
          </a:xfrm>
        </p:grpSpPr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4185683B-0C9B-3F1C-E690-154713CABF61}"/>
                </a:ext>
              </a:extLst>
            </p:cNvPr>
            <p:cNvGrpSpPr/>
            <p:nvPr/>
          </p:nvGrpSpPr>
          <p:grpSpPr>
            <a:xfrm>
              <a:off x="2849725" y="4431425"/>
              <a:ext cx="6198251" cy="1562673"/>
              <a:chOff x="2849725" y="4431425"/>
              <a:chExt cx="6198251" cy="1562673"/>
            </a:xfrm>
          </p:grpSpPr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0A0A5E03-8D00-C292-BAC6-0A0F99D4BCB6}"/>
                  </a:ext>
                </a:extLst>
              </p:cNvPr>
              <p:cNvSpPr txBox="1"/>
              <p:nvPr/>
            </p:nvSpPr>
            <p:spPr>
              <a:xfrm>
                <a:off x="2849725" y="5627066"/>
                <a:ext cx="79280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c)</a:t>
                </a:r>
              </a:p>
            </p:txBody>
          </p:sp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3BF77DC7-E679-4CA8-8F35-A77B697467B0}"/>
                  </a:ext>
                </a:extLst>
              </p:cNvPr>
              <p:cNvPicPr/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7845" b="3798"/>
              <a:stretch/>
            </p:blipFill>
            <p:spPr bwMode="auto">
              <a:xfrm>
                <a:off x="2951977" y="5434276"/>
                <a:ext cx="6095999" cy="559822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38DA2BCF-AF0E-D91B-057A-F3C955A42BBD}"/>
                  </a:ext>
                </a:extLst>
              </p:cNvPr>
              <p:cNvSpPr/>
              <p:nvPr/>
            </p:nvSpPr>
            <p:spPr>
              <a:xfrm>
                <a:off x="3311371" y="5273677"/>
                <a:ext cx="491998" cy="23672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829CFC98-37FA-3374-E5E2-D1F6755942BB}"/>
                  </a:ext>
                </a:extLst>
              </p:cNvPr>
              <p:cNvPicPr/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516" t="48865" r="3404" b="38056"/>
              <a:stretch/>
            </p:blipFill>
            <p:spPr bwMode="auto">
              <a:xfrm>
                <a:off x="3231473" y="4431425"/>
                <a:ext cx="5592931" cy="1003176"/>
              </a:xfrm>
              <a:prstGeom prst="rect">
                <a:avLst/>
              </a:prstGeom>
              <a:noFill/>
              <a:ln>
                <a:noFill/>
              </a:ln>
            </p:spPr>
          </p:pic>
        </p:grp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CDBCBCF7-D852-9B00-F190-38F7C7826E06}"/>
                </a:ext>
              </a:extLst>
            </p:cNvPr>
            <p:cNvSpPr/>
            <p:nvPr/>
          </p:nvSpPr>
          <p:spPr>
            <a:xfrm>
              <a:off x="3311371" y="4296792"/>
              <a:ext cx="331158" cy="23672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id="{AFF3FBEC-4428-F98F-F91D-D928D60A31EC}"/>
              </a:ext>
            </a:extLst>
          </p:cNvPr>
          <p:cNvSpPr txBox="1"/>
          <p:nvPr/>
        </p:nvSpPr>
        <p:spPr>
          <a:xfrm>
            <a:off x="2948396" y="5754605"/>
            <a:ext cx="7928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</a:p>
        </p:txBody>
      </p:sp>
    </p:spTree>
    <p:extLst>
      <p:ext uri="{BB962C8B-B14F-4D97-AF65-F5344CB8AC3E}">
        <p14:creationId xmlns:p14="http://schemas.microsoft.com/office/powerpoint/2010/main" val="65585125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5AD3718-18A0-01ED-637E-BB6DB735A1D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65" t="6861" r="5215" b="25696"/>
          <a:stretch/>
        </p:blipFill>
        <p:spPr>
          <a:xfrm>
            <a:off x="2784629" y="0"/>
            <a:ext cx="6622742" cy="638001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68B4640-38B2-F1DC-8EB1-CFC4E2E836F9}"/>
              </a:ext>
            </a:extLst>
          </p:cNvPr>
          <p:cNvSpPr txBox="1"/>
          <p:nvPr/>
        </p:nvSpPr>
        <p:spPr>
          <a:xfrm>
            <a:off x="1615736" y="6380015"/>
            <a:ext cx="90108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4. </a:t>
            </a:r>
            <a:r>
              <a:rPr lang="en-IN" sz="1400" dirty="0"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HPLC chromatogram of BCS3</a:t>
            </a:r>
            <a:endParaRPr lang="en-IN" sz="14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20912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35D8713-82FA-2BFB-52CD-65837B931D20}"/>
              </a:ext>
            </a:extLst>
          </p:cNvPr>
          <p:cNvSpPr txBox="1"/>
          <p:nvPr/>
        </p:nvSpPr>
        <p:spPr>
          <a:xfrm>
            <a:off x="605161" y="390617"/>
            <a:ext cx="10981678" cy="33547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600" b="1" kern="1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The IR, </a:t>
            </a:r>
            <a:r>
              <a:rPr lang="en-US" sz="1600" b="1" kern="100" baseline="30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1</a:t>
            </a:r>
            <a:r>
              <a:rPr lang="en-US" sz="1600" b="1" kern="1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H NMR, </a:t>
            </a:r>
            <a:r>
              <a:rPr lang="en-US" sz="1600" b="1" kern="100" baseline="30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13</a:t>
            </a:r>
            <a:r>
              <a:rPr lang="en-US" sz="1600" b="1" kern="1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C NMR and ESI-MS data and spectra of</a:t>
            </a:r>
            <a:r>
              <a:rPr lang="en-IN" sz="16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1-(4-chlorophenyl)-N-(4-ethoxyphenyl)</a:t>
            </a:r>
            <a:r>
              <a:rPr lang="en-IN" sz="1600" b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thanimine</a:t>
            </a:r>
            <a:r>
              <a:rPr lang="en-IN" sz="1600" b="1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IN" sz="16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CS3):</a:t>
            </a:r>
            <a:r>
              <a:rPr lang="en-US" sz="16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endParaRPr lang="en-IN" sz="1600" kern="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r>
              <a:rPr lang="en-US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design and synthesis of BCS3 was done after slight modifications in the scheme proposed by Sahu et al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cheme I). </a:t>
            </a:r>
            <a:r>
              <a:rPr lang="en-I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 solution of 4-chlorobenzaldehyde (1 mol, 1000mg), 4-ethoxyaniline (1 mol, 0.975ml) and glacial acetic acid (10 drops) was added into ethanol (10 ml). The reaction mixture was then refluxed for 8 hours at 200℃ with constant stirring. After cooling the mixture at room temperature, the solvent was evaporated at low pressure using a rotary evaporator to obtain the crude product (BCS3). BCS3 was then dried at room temperature, recrystallized with chloroform to obtain the pure compound (BCS3).</a:t>
            </a:r>
            <a:endParaRPr lang="en-IN" sz="1600" kern="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r>
              <a:rPr lang="en-US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eenish brown powder; yield: 91.8% (traditional); </a:t>
            </a:r>
            <a:r>
              <a:rPr lang="en-US" sz="16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.p.</a:t>
            </a:r>
            <a:r>
              <a:rPr lang="en-US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112.0-114.1℃; IR (KBr, cm</a:t>
            </a:r>
            <a:r>
              <a:rPr lang="en-US" sz="16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1</a:t>
            </a:r>
            <a:r>
              <a:rPr lang="en-US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: 777.26 (R-Cl), 692.40 (</a:t>
            </a:r>
            <a:r>
              <a:rPr lang="en-US" sz="16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</a:t>
            </a:r>
            <a:r>
              <a:rPr lang="en-US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H), 1622.02 (C=N), 1718/1733 (OCH</a:t>
            </a:r>
            <a:r>
              <a:rPr lang="en-US" sz="1600" kern="100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H</a:t>
            </a:r>
            <a:r>
              <a:rPr lang="en-US" sz="1600" kern="100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</a:t>
            </a:r>
            <a:r>
              <a:rPr lang="en-US" sz="16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 NMR (400MHz, CDCl</a:t>
            </a:r>
            <a:r>
              <a:rPr lang="en-US" sz="1600" kern="100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US" sz="16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δ</a:t>
            </a:r>
            <a:r>
              <a:rPr lang="en-US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1.383-1.41 </a:t>
            </a:r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t, </a:t>
            </a:r>
            <a:r>
              <a:rPr lang="en-US" sz="1600" i="1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J </a:t>
            </a:r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 7.0 Hz, 2H</a:t>
            </a:r>
            <a:r>
              <a:rPr lang="en-US" sz="1600" kern="100" dirty="0">
                <a:solidFill>
                  <a:srgbClr val="FF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r>
              <a:rPr lang="en-US" sz="1600" kern="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lang="en-US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3.992-4.05 </a:t>
            </a:r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600" kern="100" dirty="0">
                <a:solidFill>
                  <a:srgbClr val="FF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q</a:t>
            </a:r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600" i="1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J</a:t>
            </a:r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= 6.8 Hz, 3H)</a:t>
            </a:r>
            <a:r>
              <a:rPr lang="en-US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6.882-7.80 (m, 8H, </a:t>
            </a:r>
            <a:r>
              <a:rPr lang="en-US" sz="16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</a:t>
            </a:r>
            <a:r>
              <a:rPr lang="en-US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H), 8.41 (s, 1H, CH); </a:t>
            </a:r>
            <a:r>
              <a:rPr lang="en-US" sz="16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3</a:t>
            </a:r>
            <a:r>
              <a:rPr lang="en-US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 NMR (101MHz, CDCl</a:t>
            </a:r>
            <a:r>
              <a:rPr lang="en-US" sz="1600" kern="100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US" sz="16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δ</a:t>
            </a:r>
            <a:r>
              <a:rPr lang="en-US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14.95, 63.6, 115.05, 122.32, 129.09, 129.36, 129.55, 129.65, 129.79, 131.79, 131.01, 135.03, 136.96, 144.31, 156.69, 157.94. MS (ESI): </a:t>
            </a:r>
            <a:r>
              <a:rPr lang="en-US" sz="16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[M+H]</a:t>
            </a:r>
            <a:r>
              <a:rPr lang="en-US" sz="16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alculated 260.08, found 260.04; </a:t>
            </a:r>
            <a:r>
              <a:rPr lang="en-I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lemental analysis for C</a:t>
            </a:r>
            <a:r>
              <a:rPr lang="en-IN" sz="1600" kern="100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5</a:t>
            </a:r>
            <a:r>
              <a:rPr lang="en-I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IN" sz="1600" kern="100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4</a:t>
            </a:r>
            <a:r>
              <a:rPr lang="en-I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lNO (259.73 g/mol): Calculated C, 69.37; H, 5.43; N, 5.39; O, 6.16. Found: C, 69.27; H, 5.72; N, 5.21; O, 6.36.</a:t>
            </a:r>
            <a:endParaRPr lang="en-IN" sz="1600" kern="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I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433456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48C4EDEC-09D0-CA62-E46E-2087FC123C4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12116010"/>
              </p:ext>
            </p:extLst>
          </p:nvPr>
        </p:nvGraphicFramePr>
        <p:xfrm>
          <a:off x="1607845" y="1400650"/>
          <a:ext cx="8976310" cy="329129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795262">
                  <a:extLst>
                    <a:ext uri="{9D8B030D-6E8A-4147-A177-3AD203B41FA5}">
                      <a16:colId xmlns:a16="http://schemas.microsoft.com/office/drawing/2014/main" val="1487346705"/>
                    </a:ext>
                  </a:extLst>
                </a:gridCol>
                <a:gridCol w="1795262">
                  <a:extLst>
                    <a:ext uri="{9D8B030D-6E8A-4147-A177-3AD203B41FA5}">
                      <a16:colId xmlns:a16="http://schemas.microsoft.com/office/drawing/2014/main" val="1251035264"/>
                    </a:ext>
                  </a:extLst>
                </a:gridCol>
                <a:gridCol w="1795262">
                  <a:extLst>
                    <a:ext uri="{9D8B030D-6E8A-4147-A177-3AD203B41FA5}">
                      <a16:colId xmlns:a16="http://schemas.microsoft.com/office/drawing/2014/main" val="3872511570"/>
                    </a:ext>
                  </a:extLst>
                </a:gridCol>
                <a:gridCol w="1795262">
                  <a:extLst>
                    <a:ext uri="{9D8B030D-6E8A-4147-A177-3AD203B41FA5}">
                      <a16:colId xmlns:a16="http://schemas.microsoft.com/office/drawing/2014/main" val="3799547657"/>
                    </a:ext>
                  </a:extLst>
                </a:gridCol>
                <a:gridCol w="1795262">
                  <a:extLst>
                    <a:ext uri="{9D8B030D-6E8A-4147-A177-3AD203B41FA5}">
                      <a16:colId xmlns:a16="http://schemas.microsoft.com/office/drawing/2014/main" val="19431468"/>
                    </a:ext>
                  </a:extLst>
                </a:gridCol>
              </a:tblGrid>
              <a:tr h="389436">
                <a:tc rowSpan="2"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ein PDB ID</a:t>
                      </a:r>
                      <a:endParaRPr lang="en-IN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sz="16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inding affinity ΔG (Kcal mol</a:t>
                      </a:r>
                      <a:r>
                        <a:rPr lang="en-US" sz="1600" b="1" kern="1200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US" sz="16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 of azomethine derivatives</a:t>
                      </a:r>
                      <a:endParaRPr lang="en-IN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IN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IN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IN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9536321"/>
                  </a:ext>
                </a:extLst>
              </a:tr>
              <a:tr h="389436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600" b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CS1</a:t>
                      </a:r>
                      <a:endParaRPr lang="en-IN" sz="16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600" b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CS2</a:t>
                      </a:r>
                      <a:endParaRPr lang="en-IN" sz="16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600" b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CS3</a:t>
                      </a:r>
                      <a:endParaRPr lang="en-IN" sz="16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600" b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CS4</a:t>
                      </a:r>
                      <a:endParaRPr lang="en-IN" sz="16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881459569"/>
                  </a:ext>
                </a:extLst>
              </a:tr>
              <a:tr h="77887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6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XIAP (3CLX)</a:t>
                      </a:r>
                      <a:endParaRPr lang="en-IN" sz="16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6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-crystal ligand (X22): -8.3</a:t>
                      </a:r>
                      <a:endParaRPr lang="en-IN" sz="16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6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5.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6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6.3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600" b="1" kern="100" dirty="0">
                          <a:solidFill>
                            <a:srgbClr val="538135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7.8</a:t>
                      </a:r>
                      <a:endParaRPr lang="en-IN" sz="16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6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5.7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043186026"/>
                  </a:ext>
                </a:extLst>
              </a:tr>
              <a:tr h="77887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6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IAP1 (3MUP)</a:t>
                      </a:r>
                      <a:endParaRPr lang="en-IN" sz="16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6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-crystal ligand (SMK): -7.9</a:t>
                      </a:r>
                      <a:endParaRPr lang="en-IN" sz="16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6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5.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6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5.7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600" b="1" kern="100" dirty="0">
                          <a:solidFill>
                            <a:srgbClr val="538135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6.9</a:t>
                      </a:r>
                      <a:endParaRPr lang="en-IN" sz="16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6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5.1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788801132"/>
                  </a:ext>
                </a:extLst>
              </a:tr>
              <a:tr h="77887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6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IAP2 (3M0A)</a:t>
                      </a:r>
                      <a:endParaRPr lang="en-IN" sz="16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600" b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IN" sz="16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6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4.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6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4.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600" b="1" kern="100" dirty="0">
                          <a:solidFill>
                            <a:srgbClr val="538135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5.7</a:t>
                      </a:r>
                      <a:endParaRPr lang="en-IN" sz="16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6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4.9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297422867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D8D1F754-117D-343F-7CC5-8B2104F1D1BC}"/>
              </a:ext>
            </a:extLst>
          </p:cNvPr>
          <p:cNvSpPr txBox="1"/>
          <p:nvPr/>
        </p:nvSpPr>
        <p:spPr>
          <a:xfrm>
            <a:off x="1607845" y="4812418"/>
            <a:ext cx="5370990" cy="11772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2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CS1: </a:t>
            </a:r>
            <a:r>
              <a:rPr lang="en-US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-(4-chlorophenyl)-N-</a:t>
            </a:r>
            <a:r>
              <a:rPr lang="en-US" sz="12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henylmethanimine</a:t>
            </a:r>
            <a:endParaRPr lang="en-IN" sz="1200" kern="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r>
              <a:rPr lang="en-US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CS2:</a:t>
            </a:r>
            <a:r>
              <a:rPr lang="en-US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1-(4-nitrophenyl)-N-</a:t>
            </a:r>
            <a:r>
              <a:rPr lang="en-US" sz="12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henylmethanimine</a:t>
            </a:r>
            <a:endParaRPr lang="en-IN" sz="1200" kern="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r>
              <a:rPr lang="en-US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CS3:</a:t>
            </a:r>
            <a:r>
              <a:rPr lang="en-US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1-(4-chlorophenyl)-N-(4-ethoxyphenyl)</a:t>
            </a:r>
            <a:r>
              <a:rPr lang="en-US" sz="12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thanimine</a:t>
            </a:r>
            <a:endParaRPr lang="en-IN" sz="1200" kern="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r>
              <a:rPr lang="en-US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CS4:</a:t>
            </a:r>
            <a:r>
              <a:rPr lang="en-US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-(4-chlorophenyl)-N-(4-ethylphenyl)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thanimine</a:t>
            </a:r>
            <a:endParaRPr lang="en-IN" sz="1200" kern="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6F07B95-81DF-7313-9C7C-1F58E1A8F0D4}"/>
              </a:ext>
            </a:extLst>
          </p:cNvPr>
          <p:cNvSpPr txBox="1"/>
          <p:nvPr/>
        </p:nvSpPr>
        <p:spPr>
          <a:xfrm>
            <a:off x="1487009" y="868337"/>
            <a:ext cx="97077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kern="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1: </a:t>
            </a:r>
            <a:r>
              <a:rPr lang="en-IN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Binding interactions of BCS1-4 and the reference co-crystal ligands with the inhibitors of apoptosis proteins (IAPs).</a:t>
            </a:r>
            <a:endParaRPr lang="en-IN" sz="1400" dirty="0"/>
          </a:p>
        </p:txBody>
      </p:sp>
    </p:spTree>
    <p:extLst>
      <p:ext uri="{BB962C8B-B14F-4D97-AF65-F5344CB8AC3E}">
        <p14:creationId xmlns:p14="http://schemas.microsoft.com/office/powerpoint/2010/main" val="133057064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TextBox 54">
            <a:extLst>
              <a:ext uri="{FF2B5EF4-FFF2-40B4-BE49-F238E27FC236}">
                <a16:creationId xmlns:a16="http://schemas.microsoft.com/office/drawing/2014/main" id="{0DD46EAA-265B-11E5-E261-00E8825FD2B6}"/>
              </a:ext>
            </a:extLst>
          </p:cNvPr>
          <p:cNvSpPr txBox="1"/>
          <p:nvPr/>
        </p:nvSpPr>
        <p:spPr>
          <a:xfrm>
            <a:off x="334957" y="4664715"/>
            <a:ext cx="11594237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5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. </a:t>
            </a:r>
            <a:r>
              <a:rPr lang="en-IN" sz="14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mparison of redocked pose of (a) </a:t>
            </a:r>
            <a:r>
              <a:rPr lang="en-IN" sz="1400" kern="100" dirty="0">
                <a:effectLst/>
                <a:highlight>
                  <a:srgbClr val="FFFFFF"/>
                </a:highlight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3S,6S,7S,9aS)-6-{[(2S)-2-aminobutanoyl]amino}-N-(</a:t>
            </a:r>
            <a:r>
              <a:rPr lang="en-IN" sz="1400" kern="100" dirty="0" err="1">
                <a:effectLst/>
                <a:highlight>
                  <a:srgbClr val="FFFFFF"/>
                </a:highlight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phenylmethyl</a:t>
            </a:r>
            <a:r>
              <a:rPr lang="en-IN" sz="1400" kern="100" dirty="0">
                <a:effectLst/>
                <a:highlight>
                  <a:srgbClr val="FFFFFF"/>
                </a:highlight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-7 (hydroxymethyl)-5-oxooctahydro-1H-pyrrolo[1,2-a]azepine-3-carboxamide into binding site </a:t>
            </a:r>
            <a:r>
              <a:rPr lang="en-IN" sz="1400" kern="100" dirty="0">
                <a:highlight>
                  <a:srgbClr val="FFFFFF"/>
                </a:highlight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XIAP (PDB code: 3CLX) and (b) </a:t>
            </a:r>
            <a:r>
              <a:rPr lang="en-IN" sz="1400" dirty="0">
                <a:effectLst/>
                <a:highlight>
                  <a:srgbClr val="FFFFFF"/>
                </a:highlight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3S,6S,7R,9aS)-6-{[(2S)-2-aminobutanoyl]amino}-7-(2-aminoethyl)-N-(</a:t>
            </a:r>
            <a:r>
              <a:rPr lang="en-IN" sz="1400" dirty="0" err="1">
                <a:effectLst/>
                <a:highlight>
                  <a:srgbClr val="FFFFFF"/>
                </a:highlight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phenylmethyl</a:t>
            </a:r>
            <a:r>
              <a:rPr lang="en-IN" sz="1400" dirty="0">
                <a:effectLst/>
                <a:highlight>
                  <a:srgbClr val="FFFFFF"/>
                </a:highlight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-5-oxooctahydro-1H-pyrrolo[1,2-a]azepine-3-carboxamide into the binding site of cIAP1 (PDB code: 3MUP) with their native co-crystallized poses respectively. The close-</a:t>
            </a:r>
            <a:r>
              <a:rPr lang="en-IN" sz="1400" dirty="0">
                <a:highlight>
                  <a:srgbClr val="FFFFFF"/>
                </a:highlight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p views of two ligands show the confirmation of the redocked ligand (blue </a:t>
            </a:r>
            <a:r>
              <a:rPr lang="en-IN" sz="1400" dirty="0" err="1">
                <a:highlight>
                  <a:srgbClr val="FFFFFF"/>
                </a:highlight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lor</a:t>
            </a:r>
            <a:r>
              <a:rPr lang="en-IN" sz="1400" dirty="0">
                <a:highlight>
                  <a:srgbClr val="FFFFFF"/>
                </a:highlight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compared to co-crystallized one (red </a:t>
            </a:r>
            <a:r>
              <a:rPr lang="en-IN" sz="1400" dirty="0" err="1">
                <a:highlight>
                  <a:srgbClr val="FFFFFF"/>
                </a:highlight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lor</a:t>
            </a:r>
            <a:r>
              <a:rPr lang="en-IN" sz="1400" dirty="0">
                <a:highlight>
                  <a:srgbClr val="FFFFFF"/>
                </a:highlight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</a:t>
            </a:r>
            <a:endParaRPr lang="en-IN" sz="1400" kern="100" dirty="0">
              <a:effectLst/>
              <a:latin typeface="Palatino Linotype" panose="0204050205050503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r>
              <a:rPr lang="en-IN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I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EC839A3A-A4DA-1A2B-053C-71E079EE3554}"/>
              </a:ext>
            </a:extLst>
          </p:cNvPr>
          <p:cNvGrpSpPr/>
          <p:nvPr/>
        </p:nvGrpSpPr>
        <p:grpSpPr>
          <a:xfrm>
            <a:off x="2900039" y="1877216"/>
            <a:ext cx="6391922" cy="2598205"/>
            <a:chOff x="2900039" y="1877216"/>
            <a:chExt cx="6391922" cy="2598205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9598C851-AE3E-F59C-6998-3B6A7441E6A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434" t="4897" r="42247" b="47091"/>
            <a:stretch/>
          </p:blipFill>
          <p:spPr>
            <a:xfrm>
              <a:off x="3113103" y="1877216"/>
              <a:ext cx="2982897" cy="257937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E4B8AEB1-648D-6176-2A61-59D71C9C514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066" t="44367" r="28272" b="16752"/>
            <a:stretch/>
          </p:blipFill>
          <p:spPr>
            <a:xfrm>
              <a:off x="6309064" y="1877216"/>
              <a:ext cx="2982897" cy="257937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DF016D79-0833-00D8-20CB-4AA8F3931A77}"/>
                </a:ext>
              </a:extLst>
            </p:cNvPr>
            <p:cNvSpPr txBox="1"/>
            <p:nvPr/>
          </p:nvSpPr>
          <p:spPr>
            <a:xfrm>
              <a:off x="2900039" y="4179591"/>
              <a:ext cx="7928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7DF739F0-F44F-3238-5723-2F5BA336353E}"/>
                </a:ext>
              </a:extLst>
            </p:cNvPr>
            <p:cNvSpPr txBox="1"/>
            <p:nvPr/>
          </p:nvSpPr>
          <p:spPr>
            <a:xfrm>
              <a:off x="6087122" y="4198422"/>
              <a:ext cx="7928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9FE6DCC0-6B4C-EEE2-7710-BB5DEA70E0B3}"/>
                </a:ext>
              </a:extLst>
            </p:cNvPr>
            <p:cNvSpPr txBox="1"/>
            <p:nvPr/>
          </p:nvSpPr>
          <p:spPr>
            <a:xfrm>
              <a:off x="3813699" y="4044533"/>
              <a:ext cx="15728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MSD = 1.179</a:t>
              </a:r>
              <a:r>
                <a:rPr lang="en-US" sz="14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</a:rPr>
                <a:t>Å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117A4815-6FED-905B-D4CB-35A65F9D2F2B}"/>
                </a:ext>
              </a:extLst>
            </p:cNvPr>
            <p:cNvSpPr txBox="1"/>
            <p:nvPr/>
          </p:nvSpPr>
          <p:spPr>
            <a:xfrm>
              <a:off x="7014098" y="4050507"/>
              <a:ext cx="1572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MSD = </a:t>
              </a:r>
              <a:r>
                <a:rPr lang="en-US" sz="12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</a:rPr>
                <a:t>0.9489Å 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609570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13</TotalTime>
  <Words>2330</Words>
  <Application>Microsoft Office PowerPoint</Application>
  <PresentationFormat>Widescreen</PresentationFormat>
  <Paragraphs>245</Paragraphs>
  <Slides>1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5</vt:i4>
      </vt:variant>
    </vt:vector>
  </HeadingPairs>
  <TitlesOfParts>
    <vt:vector size="23" baseType="lpstr">
      <vt:lpstr>Arial</vt:lpstr>
      <vt:lpstr>Calibri</vt:lpstr>
      <vt:lpstr>Calibri Light</vt:lpstr>
      <vt:lpstr>Palatino Linotype</vt:lpstr>
      <vt:lpstr>Times New Roman</vt:lpstr>
      <vt:lpstr>Office Theme</vt:lpstr>
      <vt:lpstr>CS ChemDraw Drawing</vt:lpstr>
      <vt:lpstr>Chem3D XML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etuparna Acharya</dc:creator>
  <cp:lastModifiedBy>PRAN KISHORE DEB</cp:lastModifiedBy>
  <cp:revision>140</cp:revision>
  <dcterms:created xsi:type="dcterms:W3CDTF">2022-07-30T14:04:50Z</dcterms:created>
  <dcterms:modified xsi:type="dcterms:W3CDTF">2024-12-05T10:51:34Z</dcterms:modified>
</cp:coreProperties>
</file>